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0" r:id="rId2"/>
    <p:sldId id="278" r:id="rId3"/>
    <p:sldId id="258" r:id="rId4"/>
    <p:sldId id="271" r:id="rId5"/>
    <p:sldId id="272" r:id="rId6"/>
    <p:sldId id="267" r:id="rId7"/>
    <p:sldId id="264" r:id="rId8"/>
    <p:sldId id="273" r:id="rId9"/>
    <p:sldId id="279" r:id="rId10"/>
    <p:sldId id="276" r:id="rId11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>
      <p:cViewPr>
        <p:scale>
          <a:sx n="50" d="100"/>
          <a:sy n="50" d="100"/>
        </p:scale>
        <p:origin x="884" y="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17164F76-1C2B-4E57-BBB2-C9B7CDAF6524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1D4C6768-AF9D-41EF-A74D-20E0D19FD3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09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scaled 40%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CF6803-862E-438F-8CB4-D404F40503F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9321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650463-593F-44FF-8CAD-B22F71D1143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7287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A) load(file="U:/Work Files/Papers/</a:t>
            </a:r>
            <a:r>
              <a:rPr lang="en-AU" dirty="0" err="1"/>
              <a:t>Ularcirc</a:t>
            </a:r>
            <a:r>
              <a:rPr lang="en-AU" dirty="0"/>
              <a:t>/</a:t>
            </a:r>
            <a:r>
              <a:rPr lang="en-AU" dirty="0" err="1"/>
              <a:t>Hansen_Validation_RADscores.RData</a:t>
            </a:r>
            <a:r>
              <a:rPr lang="en-AU" dirty="0"/>
              <a:t>")</a:t>
            </a:r>
          </a:p>
          <a:p>
            <a:endParaRPr lang="en-AU" dirty="0"/>
          </a:p>
          <a:p>
            <a:r>
              <a:rPr lang="en-AU" dirty="0" err="1"/>
              <a:t>Plot_Ularcirc_vs_circExplorer</a:t>
            </a:r>
            <a:r>
              <a:rPr lang="en-AU" dirty="0"/>
              <a:t>(</a:t>
            </a:r>
            <a:r>
              <a:rPr lang="en-AU" dirty="0" err="1"/>
              <a:t>circExpl_output</a:t>
            </a:r>
            <a:r>
              <a:rPr lang="en-AU" dirty="0"/>
              <a:t> =  Hansen_Validation_circExplorer$SRR444655 ,  </a:t>
            </a:r>
            <a:r>
              <a:rPr lang="en-AU" dirty="0" err="1"/>
              <a:t>Ularcirc_output</a:t>
            </a:r>
            <a:r>
              <a:rPr lang="en-AU" dirty="0"/>
              <a:t> = Hansen_Validation_RADscores$SRR444655[,2:5], stranded= FALSE, </a:t>
            </a:r>
            <a:r>
              <a:rPr lang="en-AU" dirty="0" err="1"/>
              <a:t>RAD_filter</a:t>
            </a:r>
            <a:r>
              <a:rPr lang="en-AU" dirty="0"/>
              <a:t> = TRUE )</a:t>
            </a:r>
          </a:p>
          <a:p>
            <a:endParaRPr lang="en-AU" dirty="0"/>
          </a:p>
          <a:p>
            <a:endParaRPr lang="en-AU" dirty="0"/>
          </a:p>
          <a:p>
            <a:endParaRPr lang="en-AU" dirty="0"/>
          </a:p>
          <a:p>
            <a:r>
              <a:rPr lang="en-AU" dirty="0"/>
              <a:t>D ) load(file="U:/Work Files/Papers/</a:t>
            </a:r>
            <a:r>
              <a:rPr lang="en-AU" dirty="0" err="1"/>
              <a:t>Ularcirc</a:t>
            </a:r>
            <a:r>
              <a:rPr lang="en-AU" dirty="0"/>
              <a:t>/DHX9_circRNA_Analysis.RData") &gt; circExpl_output_SRR3997496$end&lt;- circExpl_output_SRR3997496$end - 1 &gt; DHX9_scramble_df &lt;- </a:t>
            </a:r>
            <a:r>
              <a:rPr lang="en-AU" dirty="0" err="1"/>
              <a:t>Plot_Ularcirc_vs_circExplorer</a:t>
            </a:r>
            <a:r>
              <a:rPr lang="en-AU" dirty="0"/>
              <a:t>(</a:t>
            </a:r>
            <a:r>
              <a:rPr lang="en-AU" dirty="0" err="1"/>
              <a:t>circExpl_output</a:t>
            </a:r>
            <a:r>
              <a:rPr lang="en-AU" dirty="0"/>
              <a:t> = circExpl_output_SRR3997496 , </a:t>
            </a:r>
            <a:r>
              <a:rPr lang="en-AU" dirty="0" err="1"/>
              <a:t>Ularcirc_output</a:t>
            </a:r>
            <a:r>
              <a:rPr lang="en-AU" dirty="0"/>
              <a:t> = Ularcirc_DHX9_siRNA_1,RAD_filter = TRUE 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530EAA-23E9-4F11-9DEA-92979B5EACF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60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809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737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815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995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78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567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549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182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124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649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090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6FB8C-5295-4ECD-94DE-044083554DC1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C7DD2-DE09-420B-9168-7766BFCCF3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57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175E2BA-3D00-48B3-B578-F6AF097E33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903" y="1337307"/>
            <a:ext cx="3605145" cy="265011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DD53204-F6FE-4503-8FE7-84DB3BF844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5365" y="2042473"/>
            <a:ext cx="1598135" cy="5803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9AA3863-2F18-4257-A283-2B2E5CD6CD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3859" y="4656850"/>
            <a:ext cx="2973940" cy="155179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90F178A-D7FB-4173-A156-C0DF5525C3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84834" y="4946254"/>
            <a:ext cx="1887400" cy="97162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F2AEA5F-0851-4680-AF73-7F69F2A3FBEB}"/>
              </a:ext>
            </a:extLst>
          </p:cNvPr>
          <p:cNvSpPr txBox="1"/>
          <p:nvPr/>
        </p:nvSpPr>
        <p:spPr>
          <a:xfrm>
            <a:off x="3941707" y="1401256"/>
            <a:ext cx="29113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Data sets that are used to generate current imag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86D4ED-FE79-4C79-809D-0D0E329EEA1C}"/>
              </a:ext>
            </a:extLst>
          </p:cNvPr>
          <p:cNvSpPr txBox="1"/>
          <p:nvPr/>
        </p:nvSpPr>
        <p:spPr>
          <a:xfrm>
            <a:off x="3941707" y="1715349"/>
            <a:ext cx="81464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Gene nam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A7FADA-9ACC-46DD-9B3C-400E7AE4886D}"/>
              </a:ext>
            </a:extLst>
          </p:cNvPr>
          <p:cNvSpPr txBox="1"/>
          <p:nvPr/>
        </p:nvSpPr>
        <p:spPr>
          <a:xfrm>
            <a:off x="4890027" y="2712548"/>
            <a:ext cx="187743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Back splice junction loop grap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422319-EA11-4024-9D13-0F1F3F3A94E0}"/>
              </a:ext>
            </a:extLst>
          </p:cNvPr>
          <p:cNvSpPr txBox="1"/>
          <p:nvPr/>
        </p:nvSpPr>
        <p:spPr>
          <a:xfrm>
            <a:off x="4770429" y="3173755"/>
            <a:ext cx="20778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Forward splice junction loop grap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82178C-5A67-4CE4-A636-E3893F4DFB1E}"/>
              </a:ext>
            </a:extLst>
          </p:cNvPr>
          <p:cNvSpPr txBox="1"/>
          <p:nvPr/>
        </p:nvSpPr>
        <p:spPr>
          <a:xfrm>
            <a:off x="4770430" y="3541089"/>
            <a:ext cx="8515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Gene mode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F7E40B-B137-4FC3-B983-84D2C5D65AAF}"/>
              </a:ext>
            </a:extLst>
          </p:cNvPr>
          <p:cNvSpPr txBox="1"/>
          <p:nvPr/>
        </p:nvSpPr>
        <p:spPr>
          <a:xfrm>
            <a:off x="5667317" y="2142053"/>
            <a:ext cx="10999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Navigation slide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0DA33A-3249-44F5-B5C3-554DAD4D9583}"/>
              </a:ext>
            </a:extLst>
          </p:cNvPr>
          <p:cNvSpPr txBox="1"/>
          <p:nvPr/>
        </p:nvSpPr>
        <p:spPr>
          <a:xfrm>
            <a:off x="-8973" y="1331640"/>
            <a:ext cx="284052" cy="362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A</a:t>
            </a:r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endParaRPr lang="en-AU" sz="1350" dirty="0"/>
          </a:p>
          <a:p>
            <a:r>
              <a:rPr lang="en-AU" sz="1350" dirty="0"/>
              <a:t>B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DB0B46A-69B8-4D69-8CD1-AF19D11A65F3}"/>
              </a:ext>
            </a:extLst>
          </p:cNvPr>
          <p:cNvCxnSpPr>
            <a:cxnSpLocks/>
          </p:cNvCxnSpPr>
          <p:nvPr/>
        </p:nvCxnSpPr>
        <p:spPr>
          <a:xfrm flipH="1">
            <a:off x="620688" y="3987426"/>
            <a:ext cx="486054" cy="7522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8EB9962-304F-4084-831D-ABF1FC50261D}"/>
              </a:ext>
            </a:extLst>
          </p:cNvPr>
          <p:cNvCxnSpPr>
            <a:cxnSpLocks/>
          </p:cNvCxnSpPr>
          <p:nvPr/>
        </p:nvCxnSpPr>
        <p:spPr>
          <a:xfrm>
            <a:off x="2437947" y="3926010"/>
            <a:ext cx="727833" cy="73083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0B94C43-EBC9-491F-A110-8FFEB1496230}"/>
              </a:ext>
            </a:extLst>
          </p:cNvPr>
          <p:cNvCxnSpPr>
            <a:stCxn id="7" idx="1"/>
          </p:cNvCxnSpPr>
          <p:nvPr/>
        </p:nvCxnSpPr>
        <p:spPr>
          <a:xfrm flipH="1" flipV="1">
            <a:off x="2987041" y="1522156"/>
            <a:ext cx="954666" cy="6058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A4F1C36-8ED0-4F9C-8A59-BF5150060B82}"/>
              </a:ext>
            </a:extLst>
          </p:cNvPr>
          <p:cNvCxnSpPr>
            <a:cxnSpLocks/>
          </p:cNvCxnSpPr>
          <p:nvPr/>
        </p:nvCxnSpPr>
        <p:spPr>
          <a:xfrm flipH="1">
            <a:off x="836712" y="1846887"/>
            <a:ext cx="3060902" cy="0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D4602440-8714-401A-BF84-917933703892}"/>
              </a:ext>
            </a:extLst>
          </p:cNvPr>
          <p:cNvCxnSpPr>
            <a:cxnSpLocks/>
          </p:cNvCxnSpPr>
          <p:nvPr/>
        </p:nvCxnSpPr>
        <p:spPr>
          <a:xfrm flipH="1">
            <a:off x="5215559" y="2264056"/>
            <a:ext cx="451758" cy="0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4C6F630-660F-41F0-8E87-FC936212084B}"/>
              </a:ext>
            </a:extLst>
          </p:cNvPr>
          <p:cNvCxnSpPr>
            <a:cxnSpLocks/>
            <a:stCxn id="10" idx="1"/>
          </p:cNvCxnSpPr>
          <p:nvPr/>
        </p:nvCxnSpPr>
        <p:spPr>
          <a:xfrm flipH="1" flipV="1">
            <a:off x="1916833" y="2827965"/>
            <a:ext cx="2973194" cy="11541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2C48C92-B6C1-434E-B6AA-A272740890EE}"/>
              </a:ext>
            </a:extLst>
          </p:cNvPr>
          <p:cNvCxnSpPr>
            <a:cxnSpLocks/>
            <a:stCxn id="11" idx="1"/>
          </p:cNvCxnSpPr>
          <p:nvPr/>
        </p:nvCxnSpPr>
        <p:spPr>
          <a:xfrm flipH="1" flipV="1">
            <a:off x="3765999" y="3288676"/>
            <a:ext cx="1004430" cy="12037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5589DC9-C4A6-43EC-819B-FC4FA35EC7B5}"/>
              </a:ext>
            </a:extLst>
          </p:cNvPr>
          <p:cNvCxnSpPr>
            <a:cxnSpLocks/>
          </p:cNvCxnSpPr>
          <p:nvPr/>
        </p:nvCxnSpPr>
        <p:spPr>
          <a:xfrm flipH="1">
            <a:off x="3880299" y="3659565"/>
            <a:ext cx="831090" cy="0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E8A8CECE-036C-4655-8433-97A4ED97B18A}"/>
              </a:ext>
            </a:extLst>
          </p:cNvPr>
          <p:cNvSpPr/>
          <p:nvPr/>
        </p:nvSpPr>
        <p:spPr>
          <a:xfrm>
            <a:off x="-43542" y="7164288"/>
            <a:ext cx="24229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Supplementary figure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C4C455-350F-4521-BB3D-B16810CD163E}"/>
              </a:ext>
            </a:extLst>
          </p:cNvPr>
          <p:cNvSpPr txBox="1"/>
          <p:nvPr/>
        </p:nvSpPr>
        <p:spPr>
          <a:xfrm>
            <a:off x="260648" y="7533620"/>
            <a:ext cx="64134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creen shots from </a:t>
            </a:r>
            <a:r>
              <a:rPr lang="en-AU" dirty="0" err="1"/>
              <a:t>Ularcirc</a:t>
            </a:r>
            <a:r>
              <a:rPr lang="en-AU" dirty="0"/>
              <a:t> showing (A) integrated visualisation of </a:t>
            </a:r>
            <a:r>
              <a:rPr lang="en-AU" dirty="0" err="1"/>
              <a:t>backsplice</a:t>
            </a:r>
            <a:r>
              <a:rPr lang="en-AU" dirty="0"/>
              <a:t> junctions and linear junctions (B) zoomed in region that provides better resolution of splice junctions  </a:t>
            </a:r>
          </a:p>
        </p:txBody>
      </p:sp>
    </p:spTree>
    <p:extLst>
      <p:ext uri="{BB962C8B-B14F-4D97-AF65-F5344CB8AC3E}">
        <p14:creationId xmlns:p14="http://schemas.microsoft.com/office/powerpoint/2010/main" val="27768094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/>
          <p:cNvSpPr txBox="1"/>
          <p:nvPr/>
        </p:nvSpPr>
        <p:spPr>
          <a:xfrm>
            <a:off x="3479526" y="2601488"/>
            <a:ext cx="2792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9432E8-00CF-4B56-B46F-C41C08C2C8D1}"/>
              </a:ext>
            </a:extLst>
          </p:cNvPr>
          <p:cNvSpPr txBox="1"/>
          <p:nvPr/>
        </p:nvSpPr>
        <p:spPr>
          <a:xfrm>
            <a:off x="4385112" y="9206265"/>
            <a:ext cx="194277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ASAP1 exon modification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F88D823-4A3E-4F7C-80A1-5033C14DF4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27" b="11649"/>
          <a:stretch/>
        </p:blipFill>
        <p:spPr>
          <a:xfrm>
            <a:off x="3773350" y="2825623"/>
            <a:ext cx="2463345" cy="163836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B0FC8B4-AAB6-45D7-830F-8C82FE85F7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591" b="11094"/>
          <a:stretch/>
        </p:blipFill>
        <p:spPr>
          <a:xfrm>
            <a:off x="620699" y="2765827"/>
            <a:ext cx="2500264" cy="169816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3668921-B52B-4AF3-AE1A-E18B84D6A7AA}"/>
              </a:ext>
            </a:extLst>
          </p:cNvPr>
          <p:cNvSpPr txBox="1"/>
          <p:nvPr/>
        </p:nvSpPr>
        <p:spPr>
          <a:xfrm>
            <a:off x="3993952" y="2686772"/>
            <a:ext cx="224452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HEK293 (DHX9 siRNA)   (SRR3997496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B8024A-7B89-403F-A490-17A8C6101335}"/>
              </a:ext>
            </a:extLst>
          </p:cNvPr>
          <p:cNvSpPr txBox="1"/>
          <p:nvPr/>
        </p:nvSpPr>
        <p:spPr>
          <a:xfrm>
            <a:off x="1160748" y="2662147"/>
            <a:ext cx="169950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Hs68 cell line  (SRR444655)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4C35967-0FC5-4E06-BFF5-719DE549B482}"/>
              </a:ext>
            </a:extLst>
          </p:cNvPr>
          <p:cNvSpPr txBox="1"/>
          <p:nvPr/>
        </p:nvSpPr>
        <p:spPr>
          <a:xfrm rot="16200000">
            <a:off x="3027595" y="3433574"/>
            <a:ext cx="1351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Ularcirc</a:t>
            </a:r>
            <a:r>
              <a:rPr lang="en-AU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BSJ count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C5C3FAF-80EC-4275-AB3F-E8088FD6BDFB}"/>
              </a:ext>
            </a:extLst>
          </p:cNvPr>
          <p:cNvSpPr txBox="1"/>
          <p:nvPr/>
        </p:nvSpPr>
        <p:spPr>
          <a:xfrm rot="16200000">
            <a:off x="-121694" y="3453207"/>
            <a:ext cx="1351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err="1">
                <a:solidFill>
                  <a:schemeClr val="tx1">
                    <a:lumMod val="65000"/>
                    <a:lumOff val="35000"/>
                  </a:schemeClr>
                </a:solidFill>
              </a:rPr>
              <a:t>Ularcirc</a:t>
            </a:r>
            <a:r>
              <a:rPr lang="en-AU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BSJ count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A0AFD65-D45E-4C72-A589-3DAF9B401E80}"/>
              </a:ext>
            </a:extLst>
          </p:cNvPr>
          <p:cNvSpPr txBox="1"/>
          <p:nvPr/>
        </p:nvSpPr>
        <p:spPr>
          <a:xfrm>
            <a:off x="4137968" y="4403013"/>
            <a:ext cx="1691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circExplorer2 BSJ count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80931B9-4E06-443E-984A-FBD82D9DED85}"/>
              </a:ext>
            </a:extLst>
          </p:cNvPr>
          <p:cNvSpPr txBox="1"/>
          <p:nvPr/>
        </p:nvSpPr>
        <p:spPr>
          <a:xfrm>
            <a:off x="980728" y="4439017"/>
            <a:ext cx="1691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circExplorer2 BSJ counts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42646" y="2627784"/>
            <a:ext cx="28405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/>
              <a:t>A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8A6C43A-0087-49A6-BF60-2C51C785548B}"/>
              </a:ext>
            </a:extLst>
          </p:cNvPr>
          <p:cNvSpPr/>
          <p:nvPr/>
        </p:nvSpPr>
        <p:spPr>
          <a:xfrm>
            <a:off x="-4006" y="6745745"/>
            <a:ext cx="670217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10</a:t>
            </a:r>
          </a:p>
          <a:p>
            <a:r>
              <a:rPr lang="en-AU" dirty="0" err="1"/>
              <a:t>Ularcirc</a:t>
            </a:r>
            <a:r>
              <a:rPr lang="en-AU" dirty="0"/>
              <a:t> is not dependent on existing gene models to detect BSJ. A) Comparison of BSJ raw counts recovered from </a:t>
            </a:r>
            <a:r>
              <a:rPr lang="en-AU" dirty="0" err="1"/>
              <a:t>Ularcirc</a:t>
            </a:r>
            <a:r>
              <a:rPr lang="en-AU" dirty="0"/>
              <a:t> and circExplorer2 for Hs68 cells. B) </a:t>
            </a:r>
            <a:r>
              <a:rPr lang="en-AU" dirty="0" err="1"/>
              <a:t>Ularcirc</a:t>
            </a:r>
            <a:r>
              <a:rPr lang="en-AU" dirty="0"/>
              <a:t> identifies abundant </a:t>
            </a:r>
            <a:r>
              <a:rPr lang="en-AU" dirty="0" err="1"/>
              <a:t>circRNAs</a:t>
            </a:r>
            <a:r>
              <a:rPr lang="en-AU" dirty="0"/>
              <a:t> from </a:t>
            </a:r>
            <a:r>
              <a:rPr lang="en-AU" i="1" dirty="0"/>
              <a:t>DHX9</a:t>
            </a:r>
            <a:r>
              <a:rPr lang="en-AU" dirty="0"/>
              <a:t> knockdown cells which were previously missed due to the use of circExplorer2.</a:t>
            </a:r>
          </a:p>
          <a:p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8934888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65">
            <a:extLst>
              <a:ext uri="{FF2B5EF4-FFF2-40B4-BE49-F238E27FC236}">
                <a16:creationId xmlns:a16="http://schemas.microsoft.com/office/drawing/2014/main" id="{D6F26A35-FDFA-480C-A6C0-F40C0E79514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712"/>
          <a:stretch/>
        </p:blipFill>
        <p:spPr>
          <a:xfrm>
            <a:off x="188641" y="579105"/>
            <a:ext cx="3096344" cy="2408719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98242AA3-261A-44BE-A860-AFD9E69704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3018" y="615603"/>
            <a:ext cx="2703494" cy="2230193"/>
          </a:xfrm>
          <a:prstGeom prst="rect">
            <a:avLst/>
          </a:prstGeom>
        </p:spPr>
      </p:pic>
      <p:sp>
        <p:nvSpPr>
          <p:cNvPr id="137" name="TextBox 136">
            <a:extLst>
              <a:ext uri="{FF2B5EF4-FFF2-40B4-BE49-F238E27FC236}">
                <a16:creationId xmlns:a16="http://schemas.microsoft.com/office/drawing/2014/main" id="{4988777B-B6C8-41CF-A9BA-060AF58DDA76}"/>
              </a:ext>
            </a:extLst>
          </p:cNvPr>
          <p:cNvSpPr txBox="1"/>
          <p:nvPr/>
        </p:nvSpPr>
        <p:spPr>
          <a:xfrm>
            <a:off x="153082" y="47817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C2D367F9-0499-41CB-9D12-9282EA3FD9AD}"/>
              </a:ext>
            </a:extLst>
          </p:cNvPr>
          <p:cNvSpPr txBox="1"/>
          <p:nvPr/>
        </p:nvSpPr>
        <p:spPr>
          <a:xfrm>
            <a:off x="3378864" y="43508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E6D87EE3-A5B5-4A9C-828E-33EE897BA8CB}"/>
              </a:ext>
            </a:extLst>
          </p:cNvPr>
          <p:cNvSpPr/>
          <p:nvPr/>
        </p:nvSpPr>
        <p:spPr>
          <a:xfrm>
            <a:off x="86385" y="6620232"/>
            <a:ext cx="6584957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2:</a:t>
            </a:r>
          </a:p>
          <a:p>
            <a:r>
              <a:rPr lang="en-AU" sz="1400" dirty="0"/>
              <a:t>Homologous regions within genes can give rise to false positive BSJ, either at (A) exon boundaries or (B) within exons. (C) The frequency of RAD scores of </a:t>
            </a:r>
            <a:r>
              <a:rPr lang="en-AU" sz="1400" dirty="0" err="1"/>
              <a:t>RNaseR</a:t>
            </a:r>
            <a:r>
              <a:rPr lang="en-AU" sz="1400" dirty="0"/>
              <a:t> resistant and sensitive BSJ. </a:t>
            </a:r>
            <a:r>
              <a:rPr lang="en-AU" sz="1400" dirty="0" err="1"/>
              <a:t>RNaseR</a:t>
            </a:r>
            <a:r>
              <a:rPr lang="en-AU" sz="1400" dirty="0"/>
              <a:t> resistance BSJ typically have a RAD score approaching 0.5 while </a:t>
            </a:r>
            <a:r>
              <a:rPr lang="en-AU" sz="1400" dirty="0" err="1"/>
              <a:t>Rnase</a:t>
            </a:r>
            <a:r>
              <a:rPr lang="en-AU" sz="1400" dirty="0"/>
              <a:t> R sensitive BSJ have are enriched at either 0 or 1. (D) Frequency of FSJ support score for </a:t>
            </a:r>
            <a:r>
              <a:rPr lang="en-AU" sz="1400" dirty="0" err="1"/>
              <a:t>RNAse</a:t>
            </a:r>
            <a:r>
              <a:rPr lang="en-AU" sz="1400" dirty="0"/>
              <a:t> R resistant and sensitive BSJ. </a:t>
            </a:r>
            <a:r>
              <a:rPr lang="en-AU" sz="1400" dirty="0" err="1"/>
              <a:t>RNAse</a:t>
            </a:r>
            <a:r>
              <a:rPr lang="en-AU" sz="1400" dirty="0"/>
              <a:t> R resistant BSJ typically have FSJ support scores greater than 0.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43ECA3F-6BC9-49A7-92AA-6D7F21516A26}"/>
              </a:ext>
            </a:extLst>
          </p:cNvPr>
          <p:cNvSpPr txBox="1"/>
          <p:nvPr/>
        </p:nvSpPr>
        <p:spPr>
          <a:xfrm rot="16200000">
            <a:off x="506581" y="4109671"/>
            <a:ext cx="75854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Frequency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26A9473D-34FA-4DC6-8E77-B5109E5D4A3C}"/>
              </a:ext>
            </a:extLst>
          </p:cNvPr>
          <p:cNvGrpSpPr/>
          <p:nvPr/>
        </p:nvGrpSpPr>
        <p:grpSpPr>
          <a:xfrm>
            <a:off x="989420" y="3507559"/>
            <a:ext cx="1813024" cy="1980205"/>
            <a:chOff x="997056" y="3833026"/>
            <a:chExt cx="1813024" cy="1980205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4D9B1CC-F2F4-4884-B028-06E6E0CF999B}"/>
                </a:ext>
              </a:extLst>
            </p:cNvPr>
            <p:cNvSpPr txBox="1"/>
            <p:nvPr/>
          </p:nvSpPr>
          <p:spPr>
            <a:xfrm>
              <a:off x="1539890" y="5559315"/>
              <a:ext cx="74571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AD scor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DCC6E88-95BD-4662-9333-E896297B5E90}"/>
                </a:ext>
              </a:extLst>
            </p:cNvPr>
            <p:cNvSpPr txBox="1"/>
            <p:nvPr/>
          </p:nvSpPr>
          <p:spPr>
            <a:xfrm>
              <a:off x="1089737" y="5414584"/>
              <a:ext cx="172034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0.0                      0.5                     1.0</a:t>
              </a:r>
            </a:p>
          </p:txBody>
        </p:sp>
        <p:pic>
          <p:nvPicPr>
            <p:cNvPr id="39" name="Picture 38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BC22473E-0DDD-4531-ACCD-99785172CA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45" t="10623" b="10297"/>
            <a:stretch/>
          </p:blipFill>
          <p:spPr>
            <a:xfrm>
              <a:off x="1016655" y="4644008"/>
              <a:ext cx="1719908" cy="825246"/>
            </a:xfrm>
            <a:prstGeom prst="rect">
              <a:avLst/>
            </a:prstGeom>
          </p:spPr>
        </p:pic>
        <p:pic>
          <p:nvPicPr>
            <p:cNvPr id="40" name="Picture 39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58DAAA45-0D1C-43FA-8833-5969A11DC8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18" t="14715" b="9400"/>
            <a:stretch/>
          </p:blipFill>
          <p:spPr>
            <a:xfrm>
              <a:off x="997056" y="3833026"/>
              <a:ext cx="1757344" cy="810982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2B7B63AB-D1A2-48B8-86CB-4EDCAFF91462}"/>
              </a:ext>
            </a:extLst>
          </p:cNvPr>
          <p:cNvSpPr txBox="1"/>
          <p:nvPr/>
        </p:nvSpPr>
        <p:spPr>
          <a:xfrm>
            <a:off x="4551200" y="5212862"/>
            <a:ext cx="113524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FSJ support scor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604572F-E936-489E-92B9-151908B1E954}"/>
              </a:ext>
            </a:extLst>
          </p:cNvPr>
          <p:cNvSpPr txBox="1"/>
          <p:nvPr/>
        </p:nvSpPr>
        <p:spPr>
          <a:xfrm>
            <a:off x="1409419" y="3325126"/>
            <a:ext cx="1149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RNaseR</a:t>
            </a:r>
            <a:r>
              <a:rPr lang="en-AU" sz="11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resistan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258BA5E-99C8-4EE6-94A8-DFC3F7B0678A}"/>
              </a:ext>
            </a:extLst>
          </p:cNvPr>
          <p:cNvSpPr txBox="1"/>
          <p:nvPr/>
        </p:nvSpPr>
        <p:spPr>
          <a:xfrm>
            <a:off x="1404900" y="4373836"/>
            <a:ext cx="11528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err="1">
                <a:solidFill>
                  <a:schemeClr val="tx1">
                    <a:lumMod val="50000"/>
                    <a:lumOff val="50000"/>
                  </a:schemeClr>
                </a:solidFill>
              </a:rPr>
              <a:t>RNaseR</a:t>
            </a:r>
            <a:r>
              <a:rPr lang="en-AU" sz="110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sensitive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B89046A8-A502-4BEA-BD7B-949328958EA3}"/>
              </a:ext>
            </a:extLst>
          </p:cNvPr>
          <p:cNvGrpSpPr/>
          <p:nvPr/>
        </p:nvGrpSpPr>
        <p:grpSpPr>
          <a:xfrm>
            <a:off x="4217973" y="3353302"/>
            <a:ext cx="1671668" cy="847936"/>
            <a:chOff x="3383805" y="3311247"/>
            <a:chExt cx="1671668" cy="847936"/>
          </a:xfrm>
        </p:grpSpPr>
        <p:pic>
          <p:nvPicPr>
            <p:cNvPr id="45" name="Picture 44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016F211E-ED98-458C-9D00-7814F715BE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6" t="16488" b="11508"/>
            <a:stretch/>
          </p:blipFill>
          <p:spPr>
            <a:xfrm>
              <a:off x="3383805" y="3420208"/>
              <a:ext cx="1671668" cy="738975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C039307-35B9-4854-A8A8-AB3B27396E31}"/>
                </a:ext>
              </a:extLst>
            </p:cNvPr>
            <p:cNvSpPr txBox="1"/>
            <p:nvPr/>
          </p:nvSpPr>
          <p:spPr>
            <a:xfrm>
              <a:off x="3640794" y="3311247"/>
              <a:ext cx="11496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NaseR</a:t>
              </a:r>
              <a:r>
                <a:rPr lang="en-AU" sz="110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 resistant</a:t>
              </a:r>
              <a:endParaRPr lang="en-AU" sz="1100" dirty="0">
                <a:solidFill>
                  <a:schemeClr val="tx1">
                    <a:lumMod val="50000"/>
                    <a:lumOff val="50000"/>
                  </a:schemeClr>
                </a:solidFill>
              </a:endParaRP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7D4420F0-BF0C-4616-AF89-CE8BF2CA0D5E}"/>
              </a:ext>
            </a:extLst>
          </p:cNvPr>
          <p:cNvGrpSpPr/>
          <p:nvPr/>
        </p:nvGrpSpPr>
        <p:grpSpPr>
          <a:xfrm>
            <a:off x="4191159" y="4286803"/>
            <a:ext cx="1766172" cy="958634"/>
            <a:chOff x="3356991" y="4233174"/>
            <a:chExt cx="1766172" cy="958634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CFD2077-FA1B-4D09-8911-762B6EE81461}"/>
                </a:ext>
              </a:extLst>
            </p:cNvPr>
            <p:cNvSpPr txBox="1"/>
            <p:nvPr/>
          </p:nvSpPr>
          <p:spPr>
            <a:xfrm>
              <a:off x="3457322" y="4960976"/>
              <a:ext cx="1665841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9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 0                         1                         2</a:t>
              </a:r>
            </a:p>
          </p:txBody>
        </p: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BFB2FB21-13DF-4E17-B5BB-76D9139366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6" t="15122" b="10979"/>
            <a:stretch/>
          </p:blipFill>
          <p:spPr>
            <a:xfrm>
              <a:off x="3356991" y="4264000"/>
              <a:ext cx="1698481" cy="746220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A1ECE51-B658-4657-9640-18469247E847}"/>
                </a:ext>
              </a:extLst>
            </p:cNvPr>
            <p:cNvSpPr txBox="1"/>
            <p:nvPr/>
          </p:nvSpPr>
          <p:spPr>
            <a:xfrm>
              <a:off x="3789040" y="4233174"/>
              <a:ext cx="11528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 err="1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RNaseR</a:t>
              </a:r>
              <a:r>
                <a:rPr lang="en-AU" sz="11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 sensitive</a:t>
              </a:r>
            </a:p>
          </p:txBody>
        </p:sp>
      </p:grpSp>
      <p:sp>
        <p:nvSpPr>
          <p:cNvPr id="51" name="Rectangle: Rounded Corners 50">
            <a:extLst>
              <a:ext uri="{FF2B5EF4-FFF2-40B4-BE49-F238E27FC236}">
                <a16:creationId xmlns:a16="http://schemas.microsoft.com/office/drawing/2014/main" id="{43349B55-7039-4838-B04D-F3DB39F2A9C8}"/>
              </a:ext>
            </a:extLst>
          </p:cNvPr>
          <p:cNvSpPr/>
          <p:nvPr/>
        </p:nvSpPr>
        <p:spPr>
          <a:xfrm>
            <a:off x="3900249" y="3299904"/>
            <a:ext cx="2127923" cy="2172781"/>
          </a:xfrm>
          <a:prstGeom prst="roundRect">
            <a:avLst>
              <a:gd name="adj" fmla="val 5922"/>
            </a:avLst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sp>
        <p:nvSpPr>
          <p:cNvPr id="52" name="Rectangle: Rounded Corners 51">
            <a:extLst>
              <a:ext uri="{FF2B5EF4-FFF2-40B4-BE49-F238E27FC236}">
                <a16:creationId xmlns:a16="http://schemas.microsoft.com/office/drawing/2014/main" id="{0E8E4E65-ECB6-49FB-B3C5-44C914E28D95}"/>
              </a:ext>
            </a:extLst>
          </p:cNvPr>
          <p:cNvSpPr/>
          <p:nvPr/>
        </p:nvSpPr>
        <p:spPr>
          <a:xfrm>
            <a:off x="693409" y="3299904"/>
            <a:ext cx="2127923" cy="2172781"/>
          </a:xfrm>
          <a:prstGeom prst="roundRect">
            <a:avLst>
              <a:gd name="adj" fmla="val 5922"/>
            </a:avLst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C317A3F-4229-4370-B38B-8A5CB692ADCA}"/>
              </a:ext>
            </a:extLst>
          </p:cNvPr>
          <p:cNvSpPr txBox="1"/>
          <p:nvPr/>
        </p:nvSpPr>
        <p:spPr>
          <a:xfrm rot="16200000">
            <a:off x="-321146" y="4252027"/>
            <a:ext cx="185999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>
                <a:solidFill>
                  <a:schemeClr val="bg1">
                    <a:lumMod val="65000"/>
                  </a:schemeClr>
                </a:solidFill>
              </a:rPr>
              <a:t>&gt; 9 counts in </a:t>
            </a:r>
            <a:r>
              <a:rPr lang="en-AU" sz="1350" dirty="0" err="1">
                <a:solidFill>
                  <a:schemeClr val="bg1">
                    <a:lumMod val="65000"/>
                  </a:schemeClr>
                </a:solidFill>
              </a:rPr>
              <a:t>Ribominus</a:t>
            </a:r>
            <a:endParaRPr lang="en-AU" sz="135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12131AC-B090-4B5A-9193-C8FF3BF4F30A}"/>
              </a:ext>
            </a:extLst>
          </p:cNvPr>
          <p:cNvSpPr txBox="1"/>
          <p:nvPr/>
        </p:nvSpPr>
        <p:spPr>
          <a:xfrm rot="16200000">
            <a:off x="2865067" y="4229703"/>
            <a:ext cx="185999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>
                <a:solidFill>
                  <a:schemeClr val="bg1">
                    <a:lumMod val="65000"/>
                  </a:schemeClr>
                </a:solidFill>
              </a:rPr>
              <a:t>&gt; 2 counts in </a:t>
            </a:r>
            <a:r>
              <a:rPr lang="en-AU" sz="1350" dirty="0" err="1">
                <a:solidFill>
                  <a:schemeClr val="bg1">
                    <a:lumMod val="65000"/>
                  </a:schemeClr>
                </a:solidFill>
              </a:rPr>
              <a:t>Ribominus</a:t>
            </a:r>
            <a:endParaRPr lang="en-AU" sz="1350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E4784C4-3243-4FC0-A69A-A391A07A6B55}"/>
              </a:ext>
            </a:extLst>
          </p:cNvPr>
          <p:cNvSpPr txBox="1"/>
          <p:nvPr/>
        </p:nvSpPr>
        <p:spPr>
          <a:xfrm>
            <a:off x="181550" y="317492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D4C563C-A07D-4296-823D-573DAE72B88A}"/>
              </a:ext>
            </a:extLst>
          </p:cNvPr>
          <p:cNvSpPr txBox="1"/>
          <p:nvPr/>
        </p:nvSpPr>
        <p:spPr>
          <a:xfrm>
            <a:off x="3407332" y="313184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996375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5DFBAC17-898A-44EE-9467-5056087FBCB8}"/>
              </a:ext>
            </a:extLst>
          </p:cNvPr>
          <p:cNvSpPr/>
          <p:nvPr/>
        </p:nvSpPr>
        <p:spPr>
          <a:xfrm>
            <a:off x="72335" y="7971217"/>
            <a:ext cx="658495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3:</a:t>
            </a:r>
          </a:p>
          <a:p>
            <a:r>
              <a:rPr lang="en-AU" dirty="0" err="1"/>
              <a:t>Ularcirc</a:t>
            </a:r>
            <a:r>
              <a:rPr lang="en-AU" dirty="0"/>
              <a:t> screenshots of annotated open reading frames of selected </a:t>
            </a:r>
            <a:r>
              <a:rPr lang="en-AU" dirty="0" err="1"/>
              <a:t>circRNAs</a:t>
            </a:r>
            <a:r>
              <a:rPr lang="en-AU" dirty="0"/>
              <a:t>. Each example highlights that a potential open reading frame extends across the circumference of the circle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8205DAB-D72D-461F-9FBB-D0BA92FCE3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2806" y="2763845"/>
            <a:ext cx="2296434" cy="226243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C261360-3DA4-4658-B427-BB3A865899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796" y="262099"/>
            <a:ext cx="2296434" cy="225013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CF0946A-AFB7-44D3-959B-184FEFAFE3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7796" y="2743696"/>
            <a:ext cx="2296434" cy="230273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F9F5D28-2B3D-4B42-B440-FC49909FD1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4230" y="271424"/>
            <a:ext cx="2296435" cy="226510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D943661-2F86-4BD0-9C06-1C9CF5C7069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64814" y="5420671"/>
            <a:ext cx="2296434" cy="227133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B3EA93C-3A91-4257-9EFF-C407D552C0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3489" y="5404381"/>
            <a:ext cx="2351007" cy="2334903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C0B1BCCD-7393-45F1-AA6F-56CC5CA0BA32}"/>
              </a:ext>
            </a:extLst>
          </p:cNvPr>
          <p:cNvSpPr/>
          <p:nvPr/>
        </p:nvSpPr>
        <p:spPr>
          <a:xfrm>
            <a:off x="3234230" y="108428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ECAA8E1-4629-4592-AA4F-368A6FFF20EE}"/>
              </a:ext>
            </a:extLst>
          </p:cNvPr>
          <p:cNvSpPr/>
          <p:nvPr/>
        </p:nvSpPr>
        <p:spPr>
          <a:xfrm>
            <a:off x="945617" y="107504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2240DD2-7C75-44EF-AC2C-A289355CA9C6}"/>
              </a:ext>
            </a:extLst>
          </p:cNvPr>
          <p:cNvSpPr/>
          <p:nvPr/>
        </p:nvSpPr>
        <p:spPr>
          <a:xfrm>
            <a:off x="3226409" y="2700716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8C8C910-CCD3-462E-ACB8-EC97CF92BD3E}"/>
              </a:ext>
            </a:extLst>
          </p:cNvPr>
          <p:cNvSpPr/>
          <p:nvPr/>
        </p:nvSpPr>
        <p:spPr>
          <a:xfrm>
            <a:off x="937796" y="2699792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7A5E6F3-CB27-4743-92BE-A93AD552DBF2}"/>
              </a:ext>
            </a:extLst>
          </p:cNvPr>
          <p:cNvSpPr/>
          <p:nvPr/>
        </p:nvSpPr>
        <p:spPr>
          <a:xfrm>
            <a:off x="3222102" y="5293004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DB8F2A3-D665-41F3-A4C7-73CE37FF3ECF}"/>
              </a:ext>
            </a:extLst>
          </p:cNvPr>
          <p:cNvSpPr/>
          <p:nvPr/>
        </p:nvSpPr>
        <p:spPr>
          <a:xfrm>
            <a:off x="933489" y="5292080"/>
            <a:ext cx="2296435" cy="25632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1815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8FDCA08-DE11-4017-8FEF-04B223259F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0808" y="2092796"/>
            <a:ext cx="3592018" cy="51435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6695C53-6C72-46A6-A57F-D0B3BEE84C86}"/>
              </a:ext>
            </a:extLst>
          </p:cNvPr>
          <p:cNvSpPr/>
          <p:nvPr/>
        </p:nvSpPr>
        <p:spPr>
          <a:xfrm>
            <a:off x="332656" y="7452320"/>
            <a:ext cx="645843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Supplementary figure 4</a:t>
            </a:r>
          </a:p>
          <a:p>
            <a:r>
              <a:rPr lang="en-AU" dirty="0" err="1"/>
              <a:t>Ularcirc</a:t>
            </a:r>
            <a:r>
              <a:rPr lang="en-AU" dirty="0"/>
              <a:t> screenshot of a </a:t>
            </a:r>
            <a:r>
              <a:rPr lang="en-AU" dirty="0" err="1"/>
              <a:t>circRNA</a:t>
            </a:r>
            <a:r>
              <a:rPr lang="en-AU" dirty="0"/>
              <a:t> and predicted miRNA binding sites.</a:t>
            </a:r>
          </a:p>
        </p:txBody>
      </p:sp>
    </p:spTree>
    <p:extLst>
      <p:ext uri="{BB962C8B-B14F-4D97-AF65-F5344CB8AC3E}">
        <p14:creationId xmlns:p14="http://schemas.microsoft.com/office/powerpoint/2010/main" val="19480059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5" name="Picture 11" descr="U:\Work Files\Papers\Ularcirc\ScreenCaptures\Alternative splicing\Ndrg4_P90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0" t="66630" r="2781" b="2141"/>
          <a:stretch/>
        </p:blipFill>
        <p:spPr bwMode="auto">
          <a:xfrm>
            <a:off x="434334" y="1245259"/>
            <a:ext cx="2658139" cy="838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U:\Work Files\Papers\Ularcirc\ScreenCaptures\Alternative splicing\Ndrg4_P1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9" t="67613" r="1892" b="18679"/>
          <a:stretch/>
        </p:blipFill>
        <p:spPr bwMode="auto">
          <a:xfrm>
            <a:off x="439649" y="614753"/>
            <a:ext cx="2652824" cy="363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E0AF62FD-FD8D-4359-A473-6374A62233D6}"/>
              </a:ext>
            </a:extLst>
          </p:cNvPr>
          <p:cNvSpPr txBox="1"/>
          <p:nvPr/>
        </p:nvSpPr>
        <p:spPr>
          <a:xfrm rot="16200000">
            <a:off x="221116" y="1675584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schemeClr val="accent6">
                    <a:lumMod val="50000"/>
                  </a:schemeClr>
                </a:solidFill>
              </a:rPr>
              <a:t>Ndrg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13B36B-919C-49E2-82EF-E0F7AEC58D1E}"/>
              </a:ext>
            </a:extLst>
          </p:cNvPr>
          <p:cNvSpPr txBox="1"/>
          <p:nvPr/>
        </p:nvSpPr>
        <p:spPr>
          <a:xfrm>
            <a:off x="765522" y="1118809"/>
            <a:ext cx="10903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>
                <a:solidFill>
                  <a:schemeClr val="bg1">
                    <a:lumMod val="50000"/>
                  </a:schemeClr>
                </a:solidFill>
              </a:rPr>
              <a:t>Linear junction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7EB9D36-E79E-4C81-9653-CA1084665033}"/>
              </a:ext>
            </a:extLst>
          </p:cNvPr>
          <p:cNvSpPr txBox="1"/>
          <p:nvPr/>
        </p:nvSpPr>
        <p:spPr>
          <a:xfrm>
            <a:off x="693514" y="470737"/>
            <a:ext cx="10903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>
                <a:solidFill>
                  <a:schemeClr val="bg1">
                    <a:lumMod val="50000"/>
                  </a:schemeClr>
                </a:solidFill>
              </a:rPr>
              <a:t>Linear junction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E08BBD-AF83-47AF-949D-073A29984AAD}"/>
              </a:ext>
            </a:extLst>
          </p:cNvPr>
          <p:cNvSpPr txBox="1"/>
          <p:nvPr/>
        </p:nvSpPr>
        <p:spPr>
          <a:xfrm>
            <a:off x="2569240" y="470737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P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F4CB7E4-6C48-4358-82D7-0904C5D7B14F}"/>
              </a:ext>
            </a:extLst>
          </p:cNvPr>
          <p:cNvSpPr txBox="1"/>
          <p:nvPr/>
        </p:nvSpPr>
        <p:spPr>
          <a:xfrm>
            <a:off x="2569240" y="1060593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P9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302EAF-364E-4F9D-A311-3A13014D7176}"/>
              </a:ext>
            </a:extLst>
          </p:cNvPr>
          <p:cNvSpPr txBox="1"/>
          <p:nvPr/>
        </p:nvSpPr>
        <p:spPr>
          <a:xfrm rot="16200000">
            <a:off x="-230557" y="917174"/>
            <a:ext cx="11544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50" dirty="0">
                <a:solidFill>
                  <a:schemeClr val="bg1">
                    <a:lumMod val="50000"/>
                  </a:schemeClr>
                </a:solidFill>
              </a:rPr>
              <a:t>Sequence counts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2F31354-894B-491F-B519-1CD382B32A3E}"/>
              </a:ext>
            </a:extLst>
          </p:cNvPr>
          <p:cNvGrpSpPr/>
          <p:nvPr/>
        </p:nvGrpSpPr>
        <p:grpSpPr>
          <a:xfrm>
            <a:off x="3516965" y="453172"/>
            <a:ext cx="3186484" cy="1656183"/>
            <a:chOff x="3444139" y="251520"/>
            <a:chExt cx="3186484" cy="1656183"/>
          </a:xfrm>
        </p:grpSpPr>
        <p:pic>
          <p:nvPicPr>
            <p:cNvPr id="1028" name="Picture 4" descr="U:\Work Files\Papers\Ularcirc\ScreenCaptures\Alternative splicing\Tnnt2_P1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9" t="66775" r="1615" b="18214"/>
            <a:stretch/>
          </p:blipFill>
          <p:spPr bwMode="auto">
            <a:xfrm>
              <a:off x="3665551" y="525760"/>
              <a:ext cx="2874718" cy="3415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U:\Work Files\Papers\Ularcirc\ScreenCaptures\Alternative splicing\Tnnt2_P90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2" t="67326" r="1774" b="2167"/>
            <a:stretch/>
          </p:blipFill>
          <p:spPr bwMode="auto">
            <a:xfrm>
              <a:off x="3657600" y="1146344"/>
              <a:ext cx="2870422" cy="6893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03A9038-DAA5-4F90-9D76-F1113EB65E44}"/>
                </a:ext>
              </a:extLst>
            </p:cNvPr>
            <p:cNvSpPr txBox="1"/>
            <p:nvPr/>
          </p:nvSpPr>
          <p:spPr>
            <a:xfrm rot="16200000">
              <a:off x="3445634" y="1528112"/>
              <a:ext cx="50526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solidFill>
                    <a:schemeClr val="accent6">
                      <a:lumMod val="50000"/>
                    </a:schemeClr>
                  </a:solidFill>
                </a:rPr>
                <a:t>Tnnt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A0B8C49-348E-4120-94AC-CC48058F935B}"/>
                </a:ext>
              </a:extLst>
            </p:cNvPr>
            <p:cNvSpPr txBox="1"/>
            <p:nvPr/>
          </p:nvSpPr>
          <p:spPr>
            <a:xfrm>
              <a:off x="6165304" y="251520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63A135A-4E5E-43BF-8A1D-EA598147713C}"/>
                </a:ext>
              </a:extLst>
            </p:cNvPr>
            <p:cNvSpPr txBox="1"/>
            <p:nvPr/>
          </p:nvSpPr>
          <p:spPr>
            <a:xfrm>
              <a:off x="6093296" y="827584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9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F900BB6-773A-41E6-B96A-4F570A261DA5}"/>
                </a:ext>
              </a:extLst>
            </p:cNvPr>
            <p:cNvSpPr txBox="1"/>
            <p:nvPr/>
          </p:nvSpPr>
          <p:spPr>
            <a:xfrm rot="16200000">
              <a:off x="2997702" y="874489"/>
              <a:ext cx="11544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solidFill>
                    <a:schemeClr val="bg1">
                      <a:lumMod val="50000"/>
                    </a:schemeClr>
                  </a:solidFill>
                </a:rPr>
                <a:t>Sequence counts</a:t>
              </a:r>
            </a:p>
          </p:txBody>
        </p:sp>
        <p:sp>
          <p:nvSpPr>
            <p:cNvPr id="18" name="Freeform: Shape 17">
              <a:extLst>
                <a:ext uri="{FF2B5EF4-FFF2-40B4-BE49-F238E27FC236}">
                  <a16:creationId xmlns:a16="http://schemas.microsoft.com/office/drawing/2014/main" id="{13EEC629-7311-4549-8199-D7297D6B4C8E}"/>
                </a:ext>
              </a:extLst>
            </p:cNvPr>
            <p:cNvSpPr/>
            <p:nvPr/>
          </p:nvSpPr>
          <p:spPr>
            <a:xfrm>
              <a:off x="6052166" y="591762"/>
              <a:ext cx="217878" cy="167700"/>
            </a:xfrm>
            <a:custGeom>
              <a:avLst/>
              <a:gdLst>
                <a:gd name="connsiteX0" fmla="*/ 0 w 220190"/>
                <a:gd name="connsiteY0" fmla="*/ 168239 h 168239"/>
                <a:gd name="connsiteX1" fmla="*/ 134560 w 220190"/>
                <a:gd name="connsiteY1" fmla="*/ 38 h 168239"/>
                <a:gd name="connsiteX2" fmla="*/ 220190 w 220190"/>
                <a:gd name="connsiteY2" fmla="*/ 156006 h 168239"/>
                <a:gd name="connsiteX0" fmla="*/ 0 w 220190"/>
                <a:gd name="connsiteY0" fmla="*/ 177409 h 177409"/>
                <a:gd name="connsiteX1" fmla="*/ 107036 w 220190"/>
                <a:gd name="connsiteY1" fmla="*/ 34 h 177409"/>
                <a:gd name="connsiteX2" fmla="*/ 220190 w 220190"/>
                <a:gd name="connsiteY2" fmla="*/ 165176 h 177409"/>
                <a:gd name="connsiteX0" fmla="*/ 0 w 220190"/>
                <a:gd name="connsiteY0" fmla="*/ 146517 h 146517"/>
                <a:gd name="connsiteX1" fmla="*/ 103978 w 220190"/>
                <a:gd name="connsiteY1" fmla="*/ 53 h 146517"/>
                <a:gd name="connsiteX2" fmla="*/ 220190 w 220190"/>
                <a:gd name="connsiteY2" fmla="*/ 134284 h 146517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50340 h 154094"/>
                <a:gd name="connsiteX1" fmla="*/ 110299 w 217878"/>
                <a:gd name="connsiteY1" fmla="*/ 4 h 154094"/>
                <a:gd name="connsiteX2" fmla="*/ 217878 w 217878"/>
                <a:gd name="connsiteY2" fmla="*/ 154094 h 154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878" h="154094">
                  <a:moveTo>
                    <a:pt x="0" y="150340"/>
                  </a:moveTo>
                  <a:cubicBezTo>
                    <a:pt x="29968" y="69195"/>
                    <a:pt x="73986" y="-622"/>
                    <a:pt x="110299" y="4"/>
                  </a:cubicBezTo>
                  <a:cubicBezTo>
                    <a:pt x="146612" y="630"/>
                    <a:pt x="193412" y="75090"/>
                    <a:pt x="217878" y="154094"/>
                  </a:cubicBezTo>
                </a:path>
              </a:pathLst>
            </a:cu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38D41F2-0F5C-43CC-981C-D7E35CFA7CA6}"/>
                </a:ext>
              </a:extLst>
            </p:cNvPr>
            <p:cNvSpPr txBox="1"/>
            <p:nvPr/>
          </p:nvSpPr>
          <p:spPr>
            <a:xfrm>
              <a:off x="3735051" y="985947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0B690B4-2F70-4782-917D-76A2E6E46D34}"/>
                </a:ext>
              </a:extLst>
            </p:cNvPr>
            <p:cNvSpPr txBox="1"/>
            <p:nvPr/>
          </p:nvSpPr>
          <p:spPr>
            <a:xfrm>
              <a:off x="3663043" y="337875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42" name="Freeform: Shape 41">
              <a:extLst>
                <a:ext uri="{FF2B5EF4-FFF2-40B4-BE49-F238E27FC236}">
                  <a16:creationId xmlns:a16="http://schemas.microsoft.com/office/drawing/2014/main" id="{9453706F-F571-4AEF-96D0-36ABB8FB932B}"/>
                </a:ext>
              </a:extLst>
            </p:cNvPr>
            <p:cNvSpPr/>
            <p:nvPr/>
          </p:nvSpPr>
          <p:spPr>
            <a:xfrm>
              <a:off x="6047748" y="1344541"/>
              <a:ext cx="217878" cy="37785"/>
            </a:xfrm>
            <a:custGeom>
              <a:avLst/>
              <a:gdLst>
                <a:gd name="connsiteX0" fmla="*/ 0 w 220190"/>
                <a:gd name="connsiteY0" fmla="*/ 168239 h 168239"/>
                <a:gd name="connsiteX1" fmla="*/ 134560 w 220190"/>
                <a:gd name="connsiteY1" fmla="*/ 38 h 168239"/>
                <a:gd name="connsiteX2" fmla="*/ 220190 w 220190"/>
                <a:gd name="connsiteY2" fmla="*/ 156006 h 168239"/>
                <a:gd name="connsiteX0" fmla="*/ 0 w 220190"/>
                <a:gd name="connsiteY0" fmla="*/ 177409 h 177409"/>
                <a:gd name="connsiteX1" fmla="*/ 107036 w 220190"/>
                <a:gd name="connsiteY1" fmla="*/ 34 h 177409"/>
                <a:gd name="connsiteX2" fmla="*/ 220190 w 220190"/>
                <a:gd name="connsiteY2" fmla="*/ 165176 h 177409"/>
                <a:gd name="connsiteX0" fmla="*/ 0 w 220190"/>
                <a:gd name="connsiteY0" fmla="*/ 146517 h 146517"/>
                <a:gd name="connsiteX1" fmla="*/ 103978 w 220190"/>
                <a:gd name="connsiteY1" fmla="*/ 53 h 146517"/>
                <a:gd name="connsiteX2" fmla="*/ 220190 w 220190"/>
                <a:gd name="connsiteY2" fmla="*/ 134284 h 146517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50340 h 154094"/>
                <a:gd name="connsiteX1" fmla="*/ 110299 w 217878"/>
                <a:gd name="connsiteY1" fmla="*/ 4 h 154094"/>
                <a:gd name="connsiteX2" fmla="*/ 217878 w 217878"/>
                <a:gd name="connsiteY2" fmla="*/ 154094 h 154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878" h="154094">
                  <a:moveTo>
                    <a:pt x="0" y="150340"/>
                  </a:moveTo>
                  <a:cubicBezTo>
                    <a:pt x="29968" y="69195"/>
                    <a:pt x="73986" y="-622"/>
                    <a:pt x="110299" y="4"/>
                  </a:cubicBezTo>
                  <a:cubicBezTo>
                    <a:pt x="146612" y="630"/>
                    <a:pt x="193412" y="75090"/>
                    <a:pt x="217878" y="154094"/>
                  </a:cubicBezTo>
                </a:path>
              </a:pathLst>
            </a:cu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D52990C-E892-42D5-A635-DDE40D6DFED0}"/>
              </a:ext>
            </a:extLst>
          </p:cNvPr>
          <p:cNvGrpSpPr/>
          <p:nvPr/>
        </p:nvGrpSpPr>
        <p:grpSpPr>
          <a:xfrm>
            <a:off x="189458" y="2805200"/>
            <a:ext cx="3115095" cy="1625977"/>
            <a:chOff x="71046" y="3410580"/>
            <a:chExt cx="3115095" cy="1625977"/>
          </a:xfrm>
        </p:grpSpPr>
        <p:pic>
          <p:nvPicPr>
            <p:cNvPr id="1033" name="Picture 9" descr="U:\Work Files\Papers\Ularcirc\ScreenCaptures\Alternative splicing\Kif3a_P90.PN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6" t="66734" r="2132" b="2613"/>
            <a:stretch/>
          </p:blipFill>
          <p:spPr bwMode="auto">
            <a:xfrm>
              <a:off x="304801" y="4318000"/>
              <a:ext cx="2844800" cy="6985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7A0A345B-BA77-4A7A-9FF0-72AB04984891}"/>
                </a:ext>
              </a:extLst>
            </p:cNvPr>
            <p:cNvGrpSpPr/>
            <p:nvPr/>
          </p:nvGrpSpPr>
          <p:grpSpPr>
            <a:xfrm>
              <a:off x="292100" y="3696956"/>
              <a:ext cx="2844800" cy="344566"/>
              <a:chOff x="292100" y="3607314"/>
              <a:chExt cx="2844800" cy="344566"/>
            </a:xfrm>
          </p:grpSpPr>
          <p:pic>
            <p:nvPicPr>
              <p:cNvPr id="1032" name="Picture 8" descr="U:\Work Files\Papers\Ularcirc\ScreenCaptures\Alternative splicing\Kif3a_P1.PN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9" t="67017" r="1989" b="17810"/>
              <a:stretch/>
            </p:blipFill>
            <p:spPr bwMode="auto">
              <a:xfrm>
                <a:off x="292100" y="3607314"/>
                <a:ext cx="2844800" cy="34456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3" name="Freeform: Shape 42">
                <a:extLst>
                  <a:ext uri="{FF2B5EF4-FFF2-40B4-BE49-F238E27FC236}">
                    <a16:creationId xmlns:a16="http://schemas.microsoft.com/office/drawing/2014/main" id="{79218E87-E189-4D9B-A4BF-312B2C69270A}"/>
                  </a:ext>
                </a:extLst>
              </p:cNvPr>
              <p:cNvSpPr/>
              <p:nvPr/>
            </p:nvSpPr>
            <p:spPr>
              <a:xfrm>
                <a:off x="1844824" y="3746206"/>
                <a:ext cx="475253" cy="95668"/>
              </a:xfrm>
              <a:custGeom>
                <a:avLst/>
                <a:gdLst>
                  <a:gd name="connsiteX0" fmla="*/ 0 w 220190"/>
                  <a:gd name="connsiteY0" fmla="*/ 168239 h 168239"/>
                  <a:gd name="connsiteX1" fmla="*/ 134560 w 220190"/>
                  <a:gd name="connsiteY1" fmla="*/ 38 h 168239"/>
                  <a:gd name="connsiteX2" fmla="*/ 220190 w 220190"/>
                  <a:gd name="connsiteY2" fmla="*/ 156006 h 168239"/>
                  <a:gd name="connsiteX0" fmla="*/ 0 w 220190"/>
                  <a:gd name="connsiteY0" fmla="*/ 177409 h 177409"/>
                  <a:gd name="connsiteX1" fmla="*/ 107036 w 220190"/>
                  <a:gd name="connsiteY1" fmla="*/ 34 h 177409"/>
                  <a:gd name="connsiteX2" fmla="*/ 220190 w 220190"/>
                  <a:gd name="connsiteY2" fmla="*/ 165176 h 177409"/>
                  <a:gd name="connsiteX0" fmla="*/ 0 w 220190"/>
                  <a:gd name="connsiteY0" fmla="*/ 146517 h 146517"/>
                  <a:gd name="connsiteX1" fmla="*/ 103978 w 220190"/>
                  <a:gd name="connsiteY1" fmla="*/ 53 h 146517"/>
                  <a:gd name="connsiteX2" fmla="*/ 220190 w 220190"/>
                  <a:gd name="connsiteY2" fmla="*/ 134284 h 146517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50340 h 154094"/>
                  <a:gd name="connsiteX1" fmla="*/ 110299 w 217878"/>
                  <a:gd name="connsiteY1" fmla="*/ 4 h 154094"/>
                  <a:gd name="connsiteX2" fmla="*/ 217878 w 217878"/>
                  <a:gd name="connsiteY2" fmla="*/ 154094 h 1540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17878" h="154094">
                    <a:moveTo>
                      <a:pt x="0" y="150340"/>
                    </a:moveTo>
                    <a:cubicBezTo>
                      <a:pt x="29968" y="69195"/>
                      <a:pt x="73986" y="-622"/>
                      <a:pt x="110299" y="4"/>
                    </a:cubicBezTo>
                    <a:cubicBezTo>
                      <a:pt x="146612" y="630"/>
                      <a:pt x="193412" y="75090"/>
                      <a:pt x="217878" y="154094"/>
                    </a:cubicBezTo>
                  </a:path>
                </a:pathLst>
              </a:custGeom>
              <a:noFill/>
              <a:ln w="63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6C677B8-DAB9-4751-BF54-353E474CD7A9}"/>
                </a:ext>
              </a:extLst>
            </p:cNvPr>
            <p:cNvSpPr txBox="1"/>
            <p:nvPr/>
          </p:nvSpPr>
          <p:spPr>
            <a:xfrm rot="16200000">
              <a:off x="119523" y="4679408"/>
              <a:ext cx="46038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solidFill>
                    <a:schemeClr val="accent6">
                      <a:lumMod val="50000"/>
                    </a:schemeClr>
                  </a:solidFill>
                </a:rPr>
                <a:t>Kif3a</a:t>
              </a:r>
            </a:p>
          </p:txBody>
        </p:sp>
        <p:sp>
          <p:nvSpPr>
            <p:cNvPr id="46" name="Freeform: Shape 45">
              <a:extLst>
                <a:ext uri="{FF2B5EF4-FFF2-40B4-BE49-F238E27FC236}">
                  <a16:creationId xmlns:a16="http://schemas.microsoft.com/office/drawing/2014/main" id="{6BBCFF17-20F4-4485-ABBC-A13DEBB24039}"/>
                </a:ext>
              </a:extLst>
            </p:cNvPr>
            <p:cNvSpPr/>
            <p:nvPr/>
          </p:nvSpPr>
          <p:spPr>
            <a:xfrm>
              <a:off x="1869841" y="4355976"/>
              <a:ext cx="455915" cy="186432"/>
            </a:xfrm>
            <a:custGeom>
              <a:avLst/>
              <a:gdLst>
                <a:gd name="connsiteX0" fmla="*/ 0 w 220190"/>
                <a:gd name="connsiteY0" fmla="*/ 168239 h 168239"/>
                <a:gd name="connsiteX1" fmla="*/ 134560 w 220190"/>
                <a:gd name="connsiteY1" fmla="*/ 38 h 168239"/>
                <a:gd name="connsiteX2" fmla="*/ 220190 w 220190"/>
                <a:gd name="connsiteY2" fmla="*/ 156006 h 168239"/>
                <a:gd name="connsiteX0" fmla="*/ 0 w 220190"/>
                <a:gd name="connsiteY0" fmla="*/ 177409 h 177409"/>
                <a:gd name="connsiteX1" fmla="*/ 107036 w 220190"/>
                <a:gd name="connsiteY1" fmla="*/ 34 h 177409"/>
                <a:gd name="connsiteX2" fmla="*/ 220190 w 220190"/>
                <a:gd name="connsiteY2" fmla="*/ 165176 h 177409"/>
                <a:gd name="connsiteX0" fmla="*/ 0 w 220190"/>
                <a:gd name="connsiteY0" fmla="*/ 146517 h 146517"/>
                <a:gd name="connsiteX1" fmla="*/ 103978 w 220190"/>
                <a:gd name="connsiteY1" fmla="*/ 53 h 146517"/>
                <a:gd name="connsiteX2" fmla="*/ 220190 w 220190"/>
                <a:gd name="connsiteY2" fmla="*/ 134284 h 146517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50340 h 154094"/>
                <a:gd name="connsiteX1" fmla="*/ 110299 w 217878"/>
                <a:gd name="connsiteY1" fmla="*/ 4 h 154094"/>
                <a:gd name="connsiteX2" fmla="*/ 217878 w 217878"/>
                <a:gd name="connsiteY2" fmla="*/ 154094 h 1540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878" h="154094">
                  <a:moveTo>
                    <a:pt x="0" y="150340"/>
                  </a:moveTo>
                  <a:cubicBezTo>
                    <a:pt x="29968" y="69195"/>
                    <a:pt x="73986" y="-622"/>
                    <a:pt x="110299" y="4"/>
                  </a:cubicBezTo>
                  <a:cubicBezTo>
                    <a:pt x="146612" y="630"/>
                    <a:pt x="193412" y="75090"/>
                    <a:pt x="217878" y="154094"/>
                  </a:cubicBezTo>
                </a:path>
              </a:pathLst>
            </a:cu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C98017F-DE03-45D1-8424-BF2CEA92715D}"/>
                </a:ext>
              </a:extLst>
            </p:cNvPr>
            <p:cNvSpPr txBox="1"/>
            <p:nvPr/>
          </p:nvSpPr>
          <p:spPr>
            <a:xfrm>
              <a:off x="476672" y="4139952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5C8A8EA-3D45-4AEF-8B15-BB8DC6449920}"/>
                </a:ext>
              </a:extLst>
            </p:cNvPr>
            <p:cNvSpPr txBox="1"/>
            <p:nvPr/>
          </p:nvSpPr>
          <p:spPr>
            <a:xfrm rot="16200000">
              <a:off x="-375391" y="4010325"/>
              <a:ext cx="11544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solidFill>
                    <a:schemeClr val="bg1">
                      <a:lumMod val="50000"/>
                    </a:schemeClr>
                  </a:solidFill>
                </a:rPr>
                <a:t>Sequence counts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071C829-5E5D-4FD6-BC35-E24520269742}"/>
                </a:ext>
              </a:extLst>
            </p:cNvPr>
            <p:cNvSpPr txBox="1"/>
            <p:nvPr/>
          </p:nvSpPr>
          <p:spPr>
            <a:xfrm>
              <a:off x="476672" y="3491880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BA88132-1103-4764-BD2D-4FFE9DF6415F}"/>
                </a:ext>
              </a:extLst>
            </p:cNvPr>
            <p:cNvSpPr txBox="1"/>
            <p:nvPr/>
          </p:nvSpPr>
          <p:spPr>
            <a:xfrm>
              <a:off x="2648814" y="3410580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2EBF3DD-B138-4C37-AC73-886D4AD12D45}"/>
                </a:ext>
              </a:extLst>
            </p:cNvPr>
            <p:cNvSpPr txBox="1"/>
            <p:nvPr/>
          </p:nvSpPr>
          <p:spPr>
            <a:xfrm>
              <a:off x="2648814" y="4058652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90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A3FBDCA6-5D74-4701-A04C-D93E3471940E}"/>
              </a:ext>
            </a:extLst>
          </p:cNvPr>
          <p:cNvGrpSpPr/>
          <p:nvPr/>
        </p:nvGrpSpPr>
        <p:grpSpPr>
          <a:xfrm>
            <a:off x="3596053" y="2793368"/>
            <a:ext cx="3159616" cy="1697654"/>
            <a:chOff x="85565" y="5292080"/>
            <a:chExt cx="3159616" cy="1697654"/>
          </a:xfrm>
        </p:grpSpPr>
        <p:pic>
          <p:nvPicPr>
            <p:cNvPr id="1027" name="Picture 3" descr="U:\Work Files\Papers\Ularcirc\ScreenCaptures\Alternative splicing\Tmed2_P90.PN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6" t="65989" r="1438" b="3338"/>
            <a:stretch/>
          </p:blipFill>
          <p:spPr bwMode="auto">
            <a:xfrm>
              <a:off x="300039" y="6084168"/>
              <a:ext cx="2876550" cy="8881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62AE903-EC70-4230-92A0-785DBCED813A}"/>
                </a:ext>
              </a:extLst>
            </p:cNvPr>
            <p:cNvGrpSpPr/>
            <p:nvPr/>
          </p:nvGrpSpPr>
          <p:grpSpPr>
            <a:xfrm>
              <a:off x="296168" y="5495365"/>
              <a:ext cx="2844800" cy="460382"/>
              <a:chOff x="350387" y="5423358"/>
              <a:chExt cx="2844800" cy="460382"/>
            </a:xfrm>
          </p:grpSpPr>
          <p:pic>
            <p:nvPicPr>
              <p:cNvPr id="1026" name="Picture 2" descr="U:\Work Files\Papers\Ularcirc\ScreenCaptures\Alternative splicing\Tmed2_P1.PNG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41" t="66208" r="2808" b="17918"/>
              <a:stretch/>
            </p:blipFill>
            <p:spPr bwMode="auto">
              <a:xfrm>
                <a:off x="350387" y="5423358"/>
                <a:ext cx="2844800" cy="46038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4" name="Freeform: Shape 53">
                <a:extLst>
                  <a:ext uri="{FF2B5EF4-FFF2-40B4-BE49-F238E27FC236}">
                    <a16:creationId xmlns:a16="http://schemas.microsoft.com/office/drawing/2014/main" id="{EB84717D-CA66-4D91-8C72-6186AB5B3B1E}"/>
                  </a:ext>
                </a:extLst>
              </p:cNvPr>
              <p:cNvSpPr/>
              <p:nvPr/>
            </p:nvSpPr>
            <p:spPr>
              <a:xfrm>
                <a:off x="1139190" y="5455918"/>
                <a:ext cx="1038224" cy="262495"/>
              </a:xfrm>
              <a:custGeom>
                <a:avLst/>
                <a:gdLst>
                  <a:gd name="connsiteX0" fmla="*/ 0 w 220190"/>
                  <a:gd name="connsiteY0" fmla="*/ 168239 h 168239"/>
                  <a:gd name="connsiteX1" fmla="*/ 134560 w 220190"/>
                  <a:gd name="connsiteY1" fmla="*/ 38 h 168239"/>
                  <a:gd name="connsiteX2" fmla="*/ 220190 w 220190"/>
                  <a:gd name="connsiteY2" fmla="*/ 156006 h 168239"/>
                  <a:gd name="connsiteX0" fmla="*/ 0 w 220190"/>
                  <a:gd name="connsiteY0" fmla="*/ 177409 h 177409"/>
                  <a:gd name="connsiteX1" fmla="*/ 107036 w 220190"/>
                  <a:gd name="connsiteY1" fmla="*/ 34 h 177409"/>
                  <a:gd name="connsiteX2" fmla="*/ 220190 w 220190"/>
                  <a:gd name="connsiteY2" fmla="*/ 165176 h 177409"/>
                  <a:gd name="connsiteX0" fmla="*/ 0 w 220190"/>
                  <a:gd name="connsiteY0" fmla="*/ 146517 h 146517"/>
                  <a:gd name="connsiteX1" fmla="*/ 103978 w 220190"/>
                  <a:gd name="connsiteY1" fmla="*/ 53 h 146517"/>
                  <a:gd name="connsiteX2" fmla="*/ 220190 w 220190"/>
                  <a:gd name="connsiteY2" fmla="*/ 134284 h 146517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50340 h 154094"/>
                  <a:gd name="connsiteX1" fmla="*/ 110299 w 217878"/>
                  <a:gd name="connsiteY1" fmla="*/ 4 h 154094"/>
                  <a:gd name="connsiteX2" fmla="*/ 217878 w 217878"/>
                  <a:gd name="connsiteY2" fmla="*/ 154094 h 154094"/>
                  <a:gd name="connsiteX0" fmla="*/ 0 w 217878"/>
                  <a:gd name="connsiteY0" fmla="*/ 149231 h 152985"/>
                  <a:gd name="connsiteX1" fmla="*/ 104702 w 217878"/>
                  <a:gd name="connsiteY1" fmla="*/ 5 h 152985"/>
                  <a:gd name="connsiteX2" fmla="*/ 217878 w 217878"/>
                  <a:gd name="connsiteY2" fmla="*/ 152985 h 152985"/>
                  <a:gd name="connsiteX0" fmla="*/ 0 w 217878"/>
                  <a:gd name="connsiteY0" fmla="*/ 149231 h 152985"/>
                  <a:gd name="connsiteX1" fmla="*/ 104702 w 217878"/>
                  <a:gd name="connsiteY1" fmla="*/ 5 h 152985"/>
                  <a:gd name="connsiteX2" fmla="*/ 217878 w 217878"/>
                  <a:gd name="connsiteY2" fmla="*/ 152985 h 152985"/>
                  <a:gd name="connsiteX0" fmla="*/ 0 w 217878"/>
                  <a:gd name="connsiteY0" fmla="*/ 149231 h 152985"/>
                  <a:gd name="connsiteX1" fmla="*/ 107900 w 217878"/>
                  <a:gd name="connsiteY1" fmla="*/ 5 h 152985"/>
                  <a:gd name="connsiteX2" fmla="*/ 217878 w 217878"/>
                  <a:gd name="connsiteY2" fmla="*/ 152985 h 1529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17878" h="152985">
                    <a:moveTo>
                      <a:pt x="0" y="149231"/>
                    </a:moveTo>
                    <a:cubicBezTo>
                      <a:pt x="29968" y="68086"/>
                      <a:pt x="64791" y="-621"/>
                      <a:pt x="107900" y="5"/>
                    </a:cubicBezTo>
                    <a:cubicBezTo>
                      <a:pt x="151009" y="631"/>
                      <a:pt x="193412" y="73981"/>
                      <a:pt x="217878" y="152985"/>
                    </a:cubicBezTo>
                  </a:path>
                </a:pathLst>
              </a:custGeom>
              <a:noFill/>
              <a:ln w="63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sp>
          <p:nvSpPr>
            <p:cNvPr id="55" name="Freeform: Shape 54">
              <a:extLst>
                <a:ext uri="{FF2B5EF4-FFF2-40B4-BE49-F238E27FC236}">
                  <a16:creationId xmlns:a16="http://schemas.microsoft.com/office/drawing/2014/main" id="{5D136D70-12D6-4368-9A16-A5E11A3D879D}"/>
                </a:ext>
              </a:extLst>
            </p:cNvPr>
            <p:cNvSpPr/>
            <p:nvPr/>
          </p:nvSpPr>
          <p:spPr>
            <a:xfrm>
              <a:off x="1094632" y="6341532"/>
              <a:ext cx="1038224" cy="43163"/>
            </a:xfrm>
            <a:custGeom>
              <a:avLst/>
              <a:gdLst>
                <a:gd name="connsiteX0" fmla="*/ 0 w 220190"/>
                <a:gd name="connsiteY0" fmla="*/ 168239 h 168239"/>
                <a:gd name="connsiteX1" fmla="*/ 134560 w 220190"/>
                <a:gd name="connsiteY1" fmla="*/ 38 h 168239"/>
                <a:gd name="connsiteX2" fmla="*/ 220190 w 220190"/>
                <a:gd name="connsiteY2" fmla="*/ 156006 h 168239"/>
                <a:gd name="connsiteX0" fmla="*/ 0 w 220190"/>
                <a:gd name="connsiteY0" fmla="*/ 177409 h 177409"/>
                <a:gd name="connsiteX1" fmla="*/ 107036 w 220190"/>
                <a:gd name="connsiteY1" fmla="*/ 34 h 177409"/>
                <a:gd name="connsiteX2" fmla="*/ 220190 w 220190"/>
                <a:gd name="connsiteY2" fmla="*/ 165176 h 177409"/>
                <a:gd name="connsiteX0" fmla="*/ 0 w 220190"/>
                <a:gd name="connsiteY0" fmla="*/ 146517 h 146517"/>
                <a:gd name="connsiteX1" fmla="*/ 103978 w 220190"/>
                <a:gd name="connsiteY1" fmla="*/ 53 h 146517"/>
                <a:gd name="connsiteX2" fmla="*/ 220190 w 220190"/>
                <a:gd name="connsiteY2" fmla="*/ 134284 h 146517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26306"/>
                <a:gd name="connsiteY0" fmla="*/ 146466 h 148284"/>
                <a:gd name="connsiteX1" fmla="*/ 103978 w 226306"/>
                <a:gd name="connsiteY1" fmla="*/ 2 h 148284"/>
                <a:gd name="connsiteX2" fmla="*/ 226306 w 226306"/>
                <a:gd name="connsiteY2" fmla="*/ 148284 h 148284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46468 h 150222"/>
                <a:gd name="connsiteX1" fmla="*/ 103978 w 217878"/>
                <a:gd name="connsiteY1" fmla="*/ 4 h 150222"/>
                <a:gd name="connsiteX2" fmla="*/ 217878 w 217878"/>
                <a:gd name="connsiteY2" fmla="*/ 150222 h 150222"/>
                <a:gd name="connsiteX0" fmla="*/ 0 w 217878"/>
                <a:gd name="connsiteY0" fmla="*/ 150340 h 154094"/>
                <a:gd name="connsiteX1" fmla="*/ 110299 w 217878"/>
                <a:gd name="connsiteY1" fmla="*/ 4 h 154094"/>
                <a:gd name="connsiteX2" fmla="*/ 217878 w 217878"/>
                <a:gd name="connsiteY2" fmla="*/ 154094 h 154094"/>
                <a:gd name="connsiteX0" fmla="*/ 0 w 217878"/>
                <a:gd name="connsiteY0" fmla="*/ 149231 h 152985"/>
                <a:gd name="connsiteX1" fmla="*/ 104702 w 217878"/>
                <a:gd name="connsiteY1" fmla="*/ 5 h 152985"/>
                <a:gd name="connsiteX2" fmla="*/ 217878 w 217878"/>
                <a:gd name="connsiteY2" fmla="*/ 152985 h 152985"/>
                <a:gd name="connsiteX0" fmla="*/ 0 w 217878"/>
                <a:gd name="connsiteY0" fmla="*/ 149231 h 152985"/>
                <a:gd name="connsiteX1" fmla="*/ 104702 w 217878"/>
                <a:gd name="connsiteY1" fmla="*/ 5 h 152985"/>
                <a:gd name="connsiteX2" fmla="*/ 217878 w 217878"/>
                <a:gd name="connsiteY2" fmla="*/ 152985 h 152985"/>
                <a:gd name="connsiteX0" fmla="*/ 0 w 217878"/>
                <a:gd name="connsiteY0" fmla="*/ 149231 h 152985"/>
                <a:gd name="connsiteX1" fmla="*/ 107900 w 217878"/>
                <a:gd name="connsiteY1" fmla="*/ 5 h 152985"/>
                <a:gd name="connsiteX2" fmla="*/ 217878 w 217878"/>
                <a:gd name="connsiteY2" fmla="*/ 152985 h 1529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7878" h="152985">
                  <a:moveTo>
                    <a:pt x="0" y="149231"/>
                  </a:moveTo>
                  <a:cubicBezTo>
                    <a:pt x="29968" y="68086"/>
                    <a:pt x="64791" y="-621"/>
                    <a:pt x="107900" y="5"/>
                  </a:cubicBezTo>
                  <a:cubicBezTo>
                    <a:pt x="151009" y="631"/>
                    <a:pt x="193412" y="73981"/>
                    <a:pt x="217878" y="152985"/>
                  </a:cubicBezTo>
                </a:path>
              </a:pathLst>
            </a:cu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AD0ED4B-1D6C-4002-981D-F01B4694CC44}"/>
                </a:ext>
              </a:extLst>
            </p:cNvPr>
            <p:cNvSpPr txBox="1"/>
            <p:nvPr/>
          </p:nvSpPr>
          <p:spPr>
            <a:xfrm rot="16200000">
              <a:off x="79220" y="6580487"/>
              <a:ext cx="56457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solidFill>
                    <a:schemeClr val="accent6">
                      <a:lumMod val="50000"/>
                    </a:schemeClr>
                  </a:solidFill>
                </a:rPr>
                <a:t>Tmed2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D3C87FE-3375-47F3-AE1F-4C9DCE0C86CB}"/>
                </a:ext>
              </a:extLst>
            </p:cNvPr>
            <p:cNvSpPr txBox="1"/>
            <p:nvPr/>
          </p:nvSpPr>
          <p:spPr>
            <a:xfrm rot="16200000">
              <a:off x="-360872" y="5808853"/>
              <a:ext cx="11544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solidFill>
                    <a:schemeClr val="bg1">
                      <a:lumMod val="50000"/>
                    </a:schemeClr>
                  </a:solidFill>
                </a:rPr>
                <a:t>Sequence counts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6688892-533A-460A-A434-BE727EB8F15B}"/>
                </a:ext>
              </a:extLst>
            </p:cNvPr>
            <p:cNvSpPr txBox="1"/>
            <p:nvPr/>
          </p:nvSpPr>
          <p:spPr>
            <a:xfrm>
              <a:off x="2707854" y="5332753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9F26F00-6DB5-47C7-A12E-AF5A64010352}"/>
                </a:ext>
              </a:extLst>
            </p:cNvPr>
            <p:cNvSpPr txBox="1"/>
            <p:nvPr/>
          </p:nvSpPr>
          <p:spPr>
            <a:xfrm>
              <a:off x="2707854" y="5922609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9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1572C6B-9B75-411F-B762-22A1986484C7}"/>
                </a:ext>
              </a:extLst>
            </p:cNvPr>
            <p:cNvSpPr txBox="1"/>
            <p:nvPr/>
          </p:nvSpPr>
          <p:spPr>
            <a:xfrm>
              <a:off x="404664" y="5940152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1664BAF-EA84-4884-A853-D53D84CFB91B}"/>
                </a:ext>
              </a:extLst>
            </p:cNvPr>
            <p:cNvSpPr txBox="1"/>
            <p:nvPr/>
          </p:nvSpPr>
          <p:spPr>
            <a:xfrm>
              <a:off x="404664" y="5292080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54C84DB-3AD5-441C-84F8-1CEED66EFADE}"/>
              </a:ext>
            </a:extLst>
          </p:cNvPr>
          <p:cNvGrpSpPr/>
          <p:nvPr/>
        </p:nvGrpSpPr>
        <p:grpSpPr>
          <a:xfrm>
            <a:off x="158565" y="5120645"/>
            <a:ext cx="3348694" cy="1786701"/>
            <a:chOff x="80306" y="7105779"/>
            <a:chExt cx="3348694" cy="1786701"/>
          </a:xfrm>
        </p:grpSpPr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0F0CB0B6-7461-4F3C-8A44-33C9FE1B2C4E}"/>
                </a:ext>
              </a:extLst>
            </p:cNvPr>
            <p:cNvGrpSpPr/>
            <p:nvPr/>
          </p:nvGrpSpPr>
          <p:grpSpPr>
            <a:xfrm>
              <a:off x="332656" y="7938517"/>
              <a:ext cx="3096344" cy="953963"/>
              <a:chOff x="332656" y="7938517"/>
              <a:chExt cx="3096344" cy="953963"/>
            </a:xfrm>
          </p:grpSpPr>
          <p:pic>
            <p:nvPicPr>
              <p:cNvPr id="1031" name="Picture 7" descr="U:\Work Files\Papers\Ularcirc\ScreenCaptures\Alternative splicing\Aak1_P90.PNG"/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69" t="67147" r="1752" b="2091"/>
              <a:stretch/>
            </p:blipFill>
            <p:spPr bwMode="auto">
              <a:xfrm>
                <a:off x="332656" y="7938517"/>
                <a:ext cx="3096344" cy="9539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4" name="Freeform: Shape 63">
                <a:extLst>
                  <a:ext uri="{FF2B5EF4-FFF2-40B4-BE49-F238E27FC236}">
                    <a16:creationId xmlns:a16="http://schemas.microsoft.com/office/drawing/2014/main" id="{2D02A34F-5C07-4BB6-87A3-67D38AC1F089}"/>
                  </a:ext>
                </a:extLst>
              </p:cNvPr>
              <p:cNvSpPr/>
              <p:nvPr/>
            </p:nvSpPr>
            <p:spPr>
              <a:xfrm>
                <a:off x="2963243" y="8113874"/>
                <a:ext cx="75777" cy="147298"/>
              </a:xfrm>
              <a:custGeom>
                <a:avLst/>
                <a:gdLst>
                  <a:gd name="connsiteX0" fmla="*/ 0 w 220190"/>
                  <a:gd name="connsiteY0" fmla="*/ 168239 h 168239"/>
                  <a:gd name="connsiteX1" fmla="*/ 134560 w 220190"/>
                  <a:gd name="connsiteY1" fmla="*/ 38 h 168239"/>
                  <a:gd name="connsiteX2" fmla="*/ 220190 w 220190"/>
                  <a:gd name="connsiteY2" fmla="*/ 156006 h 168239"/>
                  <a:gd name="connsiteX0" fmla="*/ 0 w 220190"/>
                  <a:gd name="connsiteY0" fmla="*/ 177409 h 177409"/>
                  <a:gd name="connsiteX1" fmla="*/ 107036 w 220190"/>
                  <a:gd name="connsiteY1" fmla="*/ 34 h 177409"/>
                  <a:gd name="connsiteX2" fmla="*/ 220190 w 220190"/>
                  <a:gd name="connsiteY2" fmla="*/ 165176 h 177409"/>
                  <a:gd name="connsiteX0" fmla="*/ 0 w 220190"/>
                  <a:gd name="connsiteY0" fmla="*/ 146517 h 146517"/>
                  <a:gd name="connsiteX1" fmla="*/ 103978 w 220190"/>
                  <a:gd name="connsiteY1" fmla="*/ 53 h 146517"/>
                  <a:gd name="connsiteX2" fmla="*/ 220190 w 220190"/>
                  <a:gd name="connsiteY2" fmla="*/ 134284 h 146517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50340 h 154094"/>
                  <a:gd name="connsiteX1" fmla="*/ 110299 w 217878"/>
                  <a:gd name="connsiteY1" fmla="*/ 4 h 154094"/>
                  <a:gd name="connsiteX2" fmla="*/ 217878 w 217878"/>
                  <a:gd name="connsiteY2" fmla="*/ 154094 h 1540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17878" h="154094">
                    <a:moveTo>
                      <a:pt x="0" y="150340"/>
                    </a:moveTo>
                    <a:cubicBezTo>
                      <a:pt x="29968" y="69195"/>
                      <a:pt x="73986" y="-622"/>
                      <a:pt x="110299" y="4"/>
                    </a:cubicBezTo>
                    <a:cubicBezTo>
                      <a:pt x="146612" y="630"/>
                      <a:pt x="193412" y="75090"/>
                      <a:pt x="217878" y="154094"/>
                    </a:cubicBezTo>
                  </a:path>
                </a:pathLst>
              </a:custGeom>
              <a:noFill/>
              <a:ln w="63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5AB81291-95A3-49ED-A35E-3B86908E3DE0}"/>
                </a:ext>
              </a:extLst>
            </p:cNvPr>
            <p:cNvGrpSpPr/>
            <p:nvPr/>
          </p:nvGrpSpPr>
          <p:grpSpPr>
            <a:xfrm>
              <a:off x="320932" y="7380312"/>
              <a:ext cx="3070026" cy="471600"/>
              <a:chOff x="358974" y="7442050"/>
              <a:chExt cx="3070026" cy="471600"/>
            </a:xfrm>
          </p:grpSpPr>
          <p:pic>
            <p:nvPicPr>
              <p:cNvPr id="1030" name="Picture 6" descr="U:\Work Files\Papers\Ularcirc\ScreenCaptures\Alternative splicing\Aak1_P1.PNG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64" t="67650" r="3214" b="17169"/>
              <a:stretch/>
            </p:blipFill>
            <p:spPr bwMode="auto">
              <a:xfrm>
                <a:off x="358974" y="7442050"/>
                <a:ext cx="3070026" cy="471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5" name="Freeform: Shape 64">
                <a:extLst>
                  <a:ext uri="{FF2B5EF4-FFF2-40B4-BE49-F238E27FC236}">
                    <a16:creationId xmlns:a16="http://schemas.microsoft.com/office/drawing/2014/main" id="{73A2A804-A590-4411-8558-89BB285D6F3A}"/>
                  </a:ext>
                </a:extLst>
              </p:cNvPr>
              <p:cNvSpPr/>
              <p:nvPr/>
            </p:nvSpPr>
            <p:spPr>
              <a:xfrm>
                <a:off x="3018142" y="7702780"/>
                <a:ext cx="75777" cy="36952"/>
              </a:xfrm>
              <a:custGeom>
                <a:avLst/>
                <a:gdLst>
                  <a:gd name="connsiteX0" fmla="*/ 0 w 220190"/>
                  <a:gd name="connsiteY0" fmla="*/ 168239 h 168239"/>
                  <a:gd name="connsiteX1" fmla="*/ 134560 w 220190"/>
                  <a:gd name="connsiteY1" fmla="*/ 38 h 168239"/>
                  <a:gd name="connsiteX2" fmla="*/ 220190 w 220190"/>
                  <a:gd name="connsiteY2" fmla="*/ 156006 h 168239"/>
                  <a:gd name="connsiteX0" fmla="*/ 0 w 220190"/>
                  <a:gd name="connsiteY0" fmla="*/ 177409 h 177409"/>
                  <a:gd name="connsiteX1" fmla="*/ 107036 w 220190"/>
                  <a:gd name="connsiteY1" fmla="*/ 34 h 177409"/>
                  <a:gd name="connsiteX2" fmla="*/ 220190 w 220190"/>
                  <a:gd name="connsiteY2" fmla="*/ 165176 h 177409"/>
                  <a:gd name="connsiteX0" fmla="*/ 0 w 220190"/>
                  <a:gd name="connsiteY0" fmla="*/ 146517 h 146517"/>
                  <a:gd name="connsiteX1" fmla="*/ 103978 w 220190"/>
                  <a:gd name="connsiteY1" fmla="*/ 53 h 146517"/>
                  <a:gd name="connsiteX2" fmla="*/ 220190 w 220190"/>
                  <a:gd name="connsiteY2" fmla="*/ 134284 h 146517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26306"/>
                  <a:gd name="connsiteY0" fmla="*/ 146466 h 148284"/>
                  <a:gd name="connsiteX1" fmla="*/ 103978 w 226306"/>
                  <a:gd name="connsiteY1" fmla="*/ 2 h 148284"/>
                  <a:gd name="connsiteX2" fmla="*/ 226306 w 226306"/>
                  <a:gd name="connsiteY2" fmla="*/ 148284 h 148284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46468 h 150222"/>
                  <a:gd name="connsiteX1" fmla="*/ 103978 w 217878"/>
                  <a:gd name="connsiteY1" fmla="*/ 4 h 150222"/>
                  <a:gd name="connsiteX2" fmla="*/ 217878 w 217878"/>
                  <a:gd name="connsiteY2" fmla="*/ 150222 h 150222"/>
                  <a:gd name="connsiteX0" fmla="*/ 0 w 217878"/>
                  <a:gd name="connsiteY0" fmla="*/ 150340 h 154094"/>
                  <a:gd name="connsiteX1" fmla="*/ 110299 w 217878"/>
                  <a:gd name="connsiteY1" fmla="*/ 4 h 154094"/>
                  <a:gd name="connsiteX2" fmla="*/ 217878 w 217878"/>
                  <a:gd name="connsiteY2" fmla="*/ 154094 h 1540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217878" h="154094">
                    <a:moveTo>
                      <a:pt x="0" y="150340"/>
                    </a:moveTo>
                    <a:cubicBezTo>
                      <a:pt x="29968" y="69195"/>
                      <a:pt x="73986" y="-622"/>
                      <a:pt x="110299" y="4"/>
                    </a:cubicBezTo>
                    <a:cubicBezTo>
                      <a:pt x="146612" y="630"/>
                      <a:pt x="193412" y="75090"/>
                      <a:pt x="217878" y="154094"/>
                    </a:cubicBezTo>
                  </a:path>
                </a:pathLst>
              </a:custGeom>
              <a:noFill/>
              <a:ln w="63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0DB9945-8A49-4574-A723-AF1287652DC1}"/>
                </a:ext>
              </a:extLst>
            </p:cNvPr>
            <p:cNvSpPr txBox="1"/>
            <p:nvPr/>
          </p:nvSpPr>
          <p:spPr>
            <a:xfrm rot="16200000">
              <a:off x="130386" y="8469977"/>
              <a:ext cx="4571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solidFill>
                    <a:schemeClr val="accent6">
                      <a:lumMod val="50000"/>
                    </a:schemeClr>
                  </a:solidFill>
                </a:rPr>
                <a:t>Aak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2301DAF-9495-47D3-B3DE-206BE7AC2A2B}"/>
                </a:ext>
              </a:extLst>
            </p:cNvPr>
            <p:cNvSpPr txBox="1"/>
            <p:nvPr/>
          </p:nvSpPr>
          <p:spPr>
            <a:xfrm>
              <a:off x="2853631" y="7105779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CC7BB3C-3779-4E03-86D0-82B773D82EDB}"/>
                </a:ext>
              </a:extLst>
            </p:cNvPr>
            <p:cNvSpPr txBox="1"/>
            <p:nvPr/>
          </p:nvSpPr>
          <p:spPr>
            <a:xfrm>
              <a:off x="2853631" y="7753851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9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B0A3814-1F77-4DD9-9F8F-33380AF96EC7}"/>
                </a:ext>
              </a:extLst>
            </p:cNvPr>
            <p:cNvSpPr txBox="1"/>
            <p:nvPr/>
          </p:nvSpPr>
          <p:spPr>
            <a:xfrm>
              <a:off x="485932" y="7799234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8484A31-8933-40FA-B762-50AFA86EFC4F}"/>
                </a:ext>
              </a:extLst>
            </p:cNvPr>
            <p:cNvSpPr txBox="1"/>
            <p:nvPr/>
          </p:nvSpPr>
          <p:spPr>
            <a:xfrm rot="16200000">
              <a:off x="-366131" y="7669607"/>
              <a:ext cx="11544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solidFill>
                    <a:schemeClr val="bg1">
                      <a:lumMod val="50000"/>
                    </a:schemeClr>
                  </a:solidFill>
                </a:rPr>
                <a:t>Sequence counts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590D38D-909D-4C5B-8E87-C872F7444418}"/>
                </a:ext>
              </a:extLst>
            </p:cNvPr>
            <p:cNvSpPr txBox="1"/>
            <p:nvPr/>
          </p:nvSpPr>
          <p:spPr>
            <a:xfrm>
              <a:off x="485932" y="7151162"/>
              <a:ext cx="10903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solidFill>
                    <a:schemeClr val="bg1">
                      <a:lumMod val="50000"/>
                    </a:schemeClr>
                  </a:solidFill>
                </a:rPr>
                <a:t>Linear junctions</a:t>
              </a: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764B3D79-9281-4E47-B925-595660A95DE3}"/>
              </a:ext>
            </a:extLst>
          </p:cNvPr>
          <p:cNvSpPr txBox="1"/>
          <p:nvPr/>
        </p:nvSpPr>
        <p:spPr>
          <a:xfrm>
            <a:off x="27935" y="10750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E1ECD2B-77F7-4957-8D12-1AD46A8AA74D}"/>
              </a:ext>
            </a:extLst>
          </p:cNvPr>
          <p:cNvSpPr txBox="1"/>
          <p:nvPr/>
        </p:nvSpPr>
        <p:spPr>
          <a:xfrm>
            <a:off x="3327308" y="1651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AEEF4E0-4F82-40F5-9E78-AC6E49BA3B1A}"/>
              </a:ext>
            </a:extLst>
          </p:cNvPr>
          <p:cNvSpPr txBox="1"/>
          <p:nvPr/>
        </p:nvSpPr>
        <p:spPr>
          <a:xfrm>
            <a:off x="-27384" y="267612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4DE5BBF-C766-4976-9EF5-5709D19D08A8}"/>
              </a:ext>
            </a:extLst>
          </p:cNvPr>
          <p:cNvSpPr txBox="1"/>
          <p:nvPr/>
        </p:nvSpPr>
        <p:spPr>
          <a:xfrm>
            <a:off x="3336926" y="267612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D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59DE464-335D-457F-8109-1AB3A2A2CFDD}"/>
              </a:ext>
            </a:extLst>
          </p:cNvPr>
          <p:cNvSpPr txBox="1"/>
          <p:nvPr/>
        </p:nvSpPr>
        <p:spPr>
          <a:xfrm>
            <a:off x="-27384" y="502584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E</a:t>
            </a:r>
          </a:p>
        </p:txBody>
      </p:sp>
      <p:sp>
        <p:nvSpPr>
          <p:cNvPr id="81" name="Freeform: Shape 80">
            <a:extLst>
              <a:ext uri="{FF2B5EF4-FFF2-40B4-BE49-F238E27FC236}">
                <a16:creationId xmlns:a16="http://schemas.microsoft.com/office/drawing/2014/main" id="{B17638B8-D98C-4379-9BE0-01C6C15F82DC}"/>
              </a:ext>
            </a:extLst>
          </p:cNvPr>
          <p:cNvSpPr/>
          <p:nvPr/>
        </p:nvSpPr>
        <p:spPr>
          <a:xfrm>
            <a:off x="2302280" y="855655"/>
            <a:ext cx="392771" cy="36885"/>
          </a:xfrm>
          <a:custGeom>
            <a:avLst/>
            <a:gdLst>
              <a:gd name="connsiteX0" fmla="*/ 0 w 220190"/>
              <a:gd name="connsiteY0" fmla="*/ 168239 h 168239"/>
              <a:gd name="connsiteX1" fmla="*/ 134560 w 220190"/>
              <a:gd name="connsiteY1" fmla="*/ 38 h 168239"/>
              <a:gd name="connsiteX2" fmla="*/ 220190 w 220190"/>
              <a:gd name="connsiteY2" fmla="*/ 156006 h 168239"/>
              <a:gd name="connsiteX0" fmla="*/ 0 w 220190"/>
              <a:gd name="connsiteY0" fmla="*/ 177409 h 177409"/>
              <a:gd name="connsiteX1" fmla="*/ 107036 w 220190"/>
              <a:gd name="connsiteY1" fmla="*/ 34 h 177409"/>
              <a:gd name="connsiteX2" fmla="*/ 220190 w 220190"/>
              <a:gd name="connsiteY2" fmla="*/ 165176 h 177409"/>
              <a:gd name="connsiteX0" fmla="*/ 0 w 220190"/>
              <a:gd name="connsiteY0" fmla="*/ 146517 h 146517"/>
              <a:gd name="connsiteX1" fmla="*/ 103978 w 220190"/>
              <a:gd name="connsiteY1" fmla="*/ 53 h 146517"/>
              <a:gd name="connsiteX2" fmla="*/ 220190 w 220190"/>
              <a:gd name="connsiteY2" fmla="*/ 134284 h 146517"/>
              <a:gd name="connsiteX0" fmla="*/ 0 w 226306"/>
              <a:gd name="connsiteY0" fmla="*/ 146466 h 148284"/>
              <a:gd name="connsiteX1" fmla="*/ 103978 w 226306"/>
              <a:gd name="connsiteY1" fmla="*/ 2 h 148284"/>
              <a:gd name="connsiteX2" fmla="*/ 226306 w 226306"/>
              <a:gd name="connsiteY2" fmla="*/ 148284 h 148284"/>
              <a:gd name="connsiteX0" fmla="*/ 0 w 226306"/>
              <a:gd name="connsiteY0" fmla="*/ 146466 h 148284"/>
              <a:gd name="connsiteX1" fmla="*/ 103978 w 226306"/>
              <a:gd name="connsiteY1" fmla="*/ 2 h 148284"/>
              <a:gd name="connsiteX2" fmla="*/ 226306 w 226306"/>
              <a:gd name="connsiteY2" fmla="*/ 148284 h 148284"/>
              <a:gd name="connsiteX0" fmla="*/ 0 w 217878"/>
              <a:gd name="connsiteY0" fmla="*/ 146468 h 150222"/>
              <a:gd name="connsiteX1" fmla="*/ 103978 w 217878"/>
              <a:gd name="connsiteY1" fmla="*/ 4 h 150222"/>
              <a:gd name="connsiteX2" fmla="*/ 217878 w 217878"/>
              <a:gd name="connsiteY2" fmla="*/ 150222 h 150222"/>
              <a:gd name="connsiteX0" fmla="*/ 0 w 217878"/>
              <a:gd name="connsiteY0" fmla="*/ 146468 h 150222"/>
              <a:gd name="connsiteX1" fmla="*/ 103978 w 217878"/>
              <a:gd name="connsiteY1" fmla="*/ 4 h 150222"/>
              <a:gd name="connsiteX2" fmla="*/ 217878 w 217878"/>
              <a:gd name="connsiteY2" fmla="*/ 150222 h 150222"/>
              <a:gd name="connsiteX0" fmla="*/ 0 w 217878"/>
              <a:gd name="connsiteY0" fmla="*/ 150340 h 154094"/>
              <a:gd name="connsiteX1" fmla="*/ 110299 w 217878"/>
              <a:gd name="connsiteY1" fmla="*/ 4 h 154094"/>
              <a:gd name="connsiteX2" fmla="*/ 217878 w 217878"/>
              <a:gd name="connsiteY2" fmla="*/ 154094 h 1540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7878" h="154094">
                <a:moveTo>
                  <a:pt x="0" y="150340"/>
                </a:moveTo>
                <a:cubicBezTo>
                  <a:pt x="29968" y="69195"/>
                  <a:pt x="73986" y="-622"/>
                  <a:pt x="110299" y="4"/>
                </a:cubicBezTo>
                <a:cubicBezTo>
                  <a:pt x="146612" y="630"/>
                  <a:pt x="193412" y="75090"/>
                  <a:pt x="217878" y="154094"/>
                </a:cubicBezTo>
              </a:path>
            </a:pathLst>
          </a:cu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FA848B9-3277-4555-9171-1E99E7659FEE}"/>
              </a:ext>
            </a:extLst>
          </p:cNvPr>
          <p:cNvSpPr txBox="1"/>
          <p:nvPr/>
        </p:nvSpPr>
        <p:spPr>
          <a:xfrm>
            <a:off x="5036168" y="5421723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>
                <a:solidFill>
                  <a:schemeClr val="accent3">
                    <a:lumMod val="75000"/>
                  </a:schemeClr>
                </a:solidFill>
              </a:rPr>
              <a:t>SRR964793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D3D1145-265A-4655-8F1E-1787B2CA86E2}"/>
              </a:ext>
            </a:extLst>
          </p:cNvPr>
          <p:cNvSpPr txBox="1"/>
          <p:nvPr/>
        </p:nvSpPr>
        <p:spPr>
          <a:xfrm>
            <a:off x="5041787" y="6075710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>
                <a:solidFill>
                  <a:schemeClr val="accent3">
                    <a:lumMod val="75000"/>
                  </a:schemeClr>
                </a:solidFill>
              </a:rPr>
              <a:t>SRR96479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E7024A8-A479-4E58-BF49-081C1464AA80}"/>
              </a:ext>
            </a:extLst>
          </p:cNvPr>
          <p:cNvSpPr txBox="1"/>
          <p:nvPr/>
        </p:nvSpPr>
        <p:spPr>
          <a:xfrm>
            <a:off x="4566966" y="5401978"/>
            <a:ext cx="538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solidFill>
                  <a:schemeClr val="accent3">
                    <a:lumMod val="75000"/>
                  </a:schemeClr>
                </a:solidFill>
              </a:rPr>
              <a:t>P1  =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545707C2-2207-4117-8A44-49F6765E0E83}"/>
              </a:ext>
            </a:extLst>
          </p:cNvPr>
          <p:cNvSpPr txBox="1"/>
          <p:nvPr/>
        </p:nvSpPr>
        <p:spPr>
          <a:xfrm>
            <a:off x="4566966" y="6050050"/>
            <a:ext cx="590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solidFill>
                  <a:schemeClr val="accent3">
                    <a:lumMod val="75000"/>
                  </a:schemeClr>
                </a:solidFill>
              </a:rPr>
              <a:t>P90 =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17AFD17C-C411-464C-94F2-469EEAA44DB4}"/>
              </a:ext>
            </a:extLst>
          </p:cNvPr>
          <p:cNvSpPr/>
          <p:nvPr/>
        </p:nvSpPr>
        <p:spPr>
          <a:xfrm>
            <a:off x="215879" y="7681042"/>
            <a:ext cx="656269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/>
              <a:t>Supplementary figure 5</a:t>
            </a:r>
          </a:p>
          <a:p>
            <a:r>
              <a:rPr lang="en-AU" dirty="0" err="1"/>
              <a:t>Ularcirc</a:t>
            </a:r>
            <a:r>
              <a:rPr lang="en-AU" dirty="0"/>
              <a:t> screenshots highlighting known alternative splicing patterns</a:t>
            </a:r>
          </a:p>
        </p:txBody>
      </p:sp>
    </p:spTree>
    <p:extLst>
      <p:ext uri="{BB962C8B-B14F-4D97-AF65-F5344CB8AC3E}">
        <p14:creationId xmlns:p14="http://schemas.microsoft.com/office/powerpoint/2010/main" val="41652672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7DDEFF98-1CC7-4D04-B4A7-166B1D62850A}"/>
              </a:ext>
            </a:extLst>
          </p:cNvPr>
          <p:cNvSpPr/>
          <p:nvPr/>
        </p:nvSpPr>
        <p:spPr>
          <a:xfrm>
            <a:off x="2510898" y="5249983"/>
            <a:ext cx="573814" cy="1220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99AEC20-CC28-4B87-87B4-DE3F06378A5E}"/>
              </a:ext>
            </a:extLst>
          </p:cNvPr>
          <p:cNvSpPr/>
          <p:nvPr/>
        </p:nvSpPr>
        <p:spPr>
          <a:xfrm>
            <a:off x="3543763" y="5249983"/>
            <a:ext cx="573814" cy="1220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C0B1261-6D1B-4341-ABEE-44BDC6A38E4F}"/>
              </a:ext>
            </a:extLst>
          </p:cNvPr>
          <p:cNvSpPr/>
          <p:nvPr/>
        </p:nvSpPr>
        <p:spPr>
          <a:xfrm>
            <a:off x="4576628" y="5249983"/>
            <a:ext cx="573814" cy="1220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2353FB5-BD4C-4A6F-B5B5-078C3F5AFD3F}"/>
              </a:ext>
            </a:extLst>
          </p:cNvPr>
          <p:cNvSpPr/>
          <p:nvPr/>
        </p:nvSpPr>
        <p:spPr>
          <a:xfrm>
            <a:off x="5609493" y="5249983"/>
            <a:ext cx="573814" cy="1220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350"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7C1252B-26E3-4956-8115-E0C0C5327E85}"/>
              </a:ext>
            </a:extLst>
          </p:cNvPr>
          <p:cNvCxnSpPr/>
          <p:nvPr/>
        </p:nvCxnSpPr>
        <p:spPr>
          <a:xfrm>
            <a:off x="3084712" y="5310990"/>
            <a:ext cx="45905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05158E64-3E92-4190-B521-F32EBDB4BFD8}"/>
              </a:ext>
            </a:extLst>
          </p:cNvPr>
          <p:cNvCxnSpPr/>
          <p:nvPr/>
        </p:nvCxnSpPr>
        <p:spPr>
          <a:xfrm>
            <a:off x="4117577" y="5310990"/>
            <a:ext cx="45905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33B4BAD7-194C-41FD-8462-9F6EC61FF021}"/>
              </a:ext>
            </a:extLst>
          </p:cNvPr>
          <p:cNvCxnSpPr/>
          <p:nvPr/>
        </p:nvCxnSpPr>
        <p:spPr>
          <a:xfrm>
            <a:off x="5150441" y="5310990"/>
            <a:ext cx="45905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387CA2A-47D3-438E-8CB5-8667FDFA7162}"/>
              </a:ext>
            </a:extLst>
          </p:cNvPr>
          <p:cNvSpPr txBox="1"/>
          <p:nvPr/>
        </p:nvSpPr>
        <p:spPr>
          <a:xfrm>
            <a:off x="109085" y="5172490"/>
            <a:ext cx="104387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Gene mode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5FEF91-7BDD-4A97-9937-BB0F29568251}"/>
              </a:ext>
            </a:extLst>
          </p:cNvPr>
          <p:cNvSpPr txBox="1"/>
          <p:nvPr/>
        </p:nvSpPr>
        <p:spPr>
          <a:xfrm>
            <a:off x="134635" y="1399039"/>
            <a:ext cx="134908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 err="1"/>
              <a:t>circRNA</a:t>
            </a:r>
            <a:r>
              <a:rPr lang="en-AU" sz="1350" dirty="0"/>
              <a:t> model 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AA6BB2B-C98D-4926-95BE-AD9EE3A6F7EF}"/>
              </a:ext>
            </a:extLst>
          </p:cNvPr>
          <p:cNvSpPr txBox="1"/>
          <p:nvPr/>
        </p:nvSpPr>
        <p:spPr>
          <a:xfrm>
            <a:off x="26623" y="3770392"/>
            <a:ext cx="134908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 err="1"/>
              <a:t>circRNA</a:t>
            </a:r>
            <a:r>
              <a:rPr lang="en-AU" sz="1350" dirty="0"/>
              <a:t> model 2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ADC7A0A9-5B6D-48CD-ABB4-BA67D87592BE}"/>
              </a:ext>
            </a:extLst>
          </p:cNvPr>
          <p:cNvGrpSpPr/>
          <p:nvPr/>
        </p:nvGrpSpPr>
        <p:grpSpPr>
          <a:xfrm>
            <a:off x="2348880" y="3984052"/>
            <a:ext cx="4158462" cy="948622"/>
            <a:chOff x="3131840" y="4941168"/>
            <a:chExt cx="5544616" cy="1264829"/>
          </a:xfrm>
        </p:grpSpPr>
        <p:sp>
          <p:nvSpPr>
            <p:cNvPr id="13" name="Arc 12">
              <a:extLst>
                <a:ext uri="{FF2B5EF4-FFF2-40B4-BE49-F238E27FC236}">
                  <a16:creationId xmlns:a16="http://schemas.microsoft.com/office/drawing/2014/main" id="{02FAE617-49A9-4E9F-9F6F-582B4738A0D1}"/>
                </a:ext>
              </a:extLst>
            </p:cNvPr>
            <p:cNvSpPr/>
            <p:nvPr/>
          </p:nvSpPr>
          <p:spPr>
            <a:xfrm>
              <a:off x="5490102" y="5229889"/>
              <a:ext cx="612068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sp>
          <p:nvSpPr>
            <p:cNvPr id="14" name="Arc 13">
              <a:extLst>
                <a:ext uri="{FF2B5EF4-FFF2-40B4-BE49-F238E27FC236}">
                  <a16:creationId xmlns:a16="http://schemas.microsoft.com/office/drawing/2014/main" id="{15FF38AE-8BCA-4090-8DB7-743C6ED069FD}"/>
                </a:ext>
              </a:extLst>
            </p:cNvPr>
            <p:cNvSpPr/>
            <p:nvPr/>
          </p:nvSpPr>
          <p:spPr>
            <a:xfrm>
              <a:off x="6867255" y="5229889"/>
              <a:ext cx="612068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sp>
          <p:nvSpPr>
            <p:cNvPr id="15" name="Arc 14">
              <a:extLst>
                <a:ext uri="{FF2B5EF4-FFF2-40B4-BE49-F238E27FC236}">
                  <a16:creationId xmlns:a16="http://schemas.microsoft.com/office/drawing/2014/main" id="{F89E7ABA-14E8-4503-8E5E-A102161D20C0}"/>
                </a:ext>
              </a:extLst>
            </p:cNvPr>
            <p:cNvSpPr/>
            <p:nvPr/>
          </p:nvSpPr>
          <p:spPr>
            <a:xfrm>
              <a:off x="4112949" y="5229889"/>
              <a:ext cx="612068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CF97BAF1-7A11-43AD-8A45-B95015D2BBE4}"/>
                </a:ext>
              </a:extLst>
            </p:cNvPr>
            <p:cNvGrpSpPr/>
            <p:nvPr/>
          </p:nvGrpSpPr>
          <p:grpSpPr>
            <a:xfrm>
              <a:off x="3131840" y="4941168"/>
              <a:ext cx="5544616" cy="792088"/>
              <a:chOff x="3131840" y="2852936"/>
              <a:chExt cx="4744144" cy="792088"/>
            </a:xfrm>
          </p:grpSpPr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8B58E803-2137-4202-9195-C19176A93F4B}"/>
                  </a:ext>
                </a:extLst>
              </p:cNvPr>
              <p:cNvCxnSpPr/>
              <p:nvPr/>
            </p:nvCxnSpPr>
            <p:spPr>
              <a:xfrm>
                <a:off x="3131840" y="2852936"/>
                <a:ext cx="0" cy="792088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D96B4031-387D-4103-8508-217A7CEEB2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31840" y="3645024"/>
                <a:ext cx="4744144" cy="0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91BDC21F-6A01-4EA6-A045-60A0723F2EA6}"/>
              </a:ext>
            </a:extLst>
          </p:cNvPr>
          <p:cNvGrpSpPr/>
          <p:nvPr/>
        </p:nvGrpSpPr>
        <p:grpSpPr>
          <a:xfrm>
            <a:off x="2348880" y="3235243"/>
            <a:ext cx="4158462" cy="974166"/>
            <a:chOff x="3131840" y="3622722"/>
            <a:chExt cx="5544616" cy="1298888"/>
          </a:xfrm>
        </p:grpSpPr>
        <p:sp>
          <p:nvSpPr>
            <p:cNvPr id="16" name="Arc 15">
              <a:extLst>
                <a:ext uri="{FF2B5EF4-FFF2-40B4-BE49-F238E27FC236}">
                  <a16:creationId xmlns:a16="http://schemas.microsoft.com/office/drawing/2014/main" id="{23C6A37E-F274-4E2F-B052-35CBA98DFFDA}"/>
                </a:ext>
              </a:extLst>
            </p:cNvPr>
            <p:cNvSpPr/>
            <p:nvPr/>
          </p:nvSpPr>
          <p:spPr>
            <a:xfrm>
              <a:off x="4725017" y="3945502"/>
              <a:ext cx="765085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B0FB0219-9F0B-4CB9-8FB5-081B6B9E3856}"/>
                </a:ext>
              </a:extLst>
            </p:cNvPr>
            <p:cNvGrpSpPr/>
            <p:nvPr/>
          </p:nvGrpSpPr>
          <p:grpSpPr>
            <a:xfrm>
              <a:off x="3131840" y="3622722"/>
              <a:ext cx="5544616" cy="792088"/>
              <a:chOff x="3131840" y="2852936"/>
              <a:chExt cx="4744144" cy="792088"/>
            </a:xfrm>
          </p:grpSpPr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187B55DC-D306-42CF-AB86-90F55892D2CE}"/>
                  </a:ext>
                </a:extLst>
              </p:cNvPr>
              <p:cNvCxnSpPr/>
              <p:nvPr/>
            </p:nvCxnSpPr>
            <p:spPr>
              <a:xfrm>
                <a:off x="3131840" y="2852936"/>
                <a:ext cx="0" cy="792088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61AE7FD5-3789-42D2-9F7B-D71FB428A97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31840" y="3645024"/>
                <a:ext cx="4744144" cy="0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DEFFA46-22F1-4D5C-84EB-DDB292ED65D1}"/>
              </a:ext>
            </a:extLst>
          </p:cNvPr>
          <p:cNvGrpSpPr/>
          <p:nvPr/>
        </p:nvGrpSpPr>
        <p:grpSpPr>
          <a:xfrm>
            <a:off x="2348880" y="1946375"/>
            <a:ext cx="4158462" cy="964832"/>
            <a:chOff x="3131840" y="598386"/>
            <a:chExt cx="5544616" cy="1286442"/>
          </a:xfrm>
        </p:grpSpPr>
        <p:sp>
          <p:nvSpPr>
            <p:cNvPr id="6" name="Arc 5">
              <a:extLst>
                <a:ext uri="{FF2B5EF4-FFF2-40B4-BE49-F238E27FC236}">
                  <a16:creationId xmlns:a16="http://schemas.microsoft.com/office/drawing/2014/main" id="{9D1A68DE-DDBA-4996-98E0-0148DD23468D}"/>
                </a:ext>
              </a:extLst>
            </p:cNvPr>
            <p:cNvSpPr/>
            <p:nvPr/>
          </p:nvSpPr>
          <p:spPr>
            <a:xfrm>
              <a:off x="4112949" y="908720"/>
              <a:ext cx="1989221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sp>
          <p:nvSpPr>
            <p:cNvPr id="7" name="Arc 6">
              <a:extLst>
                <a:ext uri="{FF2B5EF4-FFF2-40B4-BE49-F238E27FC236}">
                  <a16:creationId xmlns:a16="http://schemas.microsoft.com/office/drawing/2014/main" id="{B5539767-0322-40B0-B8CE-D113283507E9}"/>
                </a:ext>
              </a:extLst>
            </p:cNvPr>
            <p:cNvSpPr/>
            <p:nvPr/>
          </p:nvSpPr>
          <p:spPr>
            <a:xfrm>
              <a:off x="6867255" y="908720"/>
              <a:ext cx="612068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7D90E2D8-AF59-447F-88FB-A0B29F7BD06A}"/>
                </a:ext>
              </a:extLst>
            </p:cNvPr>
            <p:cNvGrpSpPr/>
            <p:nvPr/>
          </p:nvGrpSpPr>
          <p:grpSpPr>
            <a:xfrm>
              <a:off x="3131840" y="598386"/>
              <a:ext cx="5544616" cy="792088"/>
              <a:chOff x="3131840" y="2852936"/>
              <a:chExt cx="4744144" cy="792088"/>
            </a:xfrm>
          </p:grpSpPr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9696740F-FF78-42C6-832A-F34770C3FCE0}"/>
                  </a:ext>
                </a:extLst>
              </p:cNvPr>
              <p:cNvCxnSpPr/>
              <p:nvPr/>
            </p:nvCxnSpPr>
            <p:spPr>
              <a:xfrm>
                <a:off x="3131840" y="2852936"/>
                <a:ext cx="0" cy="792088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E6184500-8BB8-456E-A8FB-46D92E900D8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31840" y="3645024"/>
                <a:ext cx="4744144" cy="0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1AF4BFCB-AC44-4552-AA54-9E6CB88BF31E}"/>
              </a:ext>
            </a:extLst>
          </p:cNvPr>
          <p:cNvGrpSpPr/>
          <p:nvPr/>
        </p:nvGrpSpPr>
        <p:grpSpPr>
          <a:xfrm>
            <a:off x="2348880" y="1187624"/>
            <a:ext cx="4158462" cy="967499"/>
            <a:chOff x="3131840" y="1462482"/>
            <a:chExt cx="5544616" cy="1289998"/>
          </a:xfrm>
        </p:grpSpPr>
        <p:sp>
          <p:nvSpPr>
            <p:cNvPr id="8" name="Arc 7">
              <a:extLst>
                <a:ext uri="{FF2B5EF4-FFF2-40B4-BE49-F238E27FC236}">
                  <a16:creationId xmlns:a16="http://schemas.microsoft.com/office/drawing/2014/main" id="{EAAC0455-5FCA-426C-B28E-F9A6828D2509}"/>
                </a:ext>
              </a:extLst>
            </p:cNvPr>
            <p:cNvSpPr/>
            <p:nvPr/>
          </p:nvSpPr>
          <p:spPr>
            <a:xfrm>
              <a:off x="4725017" y="1776372"/>
              <a:ext cx="765085" cy="976108"/>
            </a:xfrm>
            <a:prstGeom prst="arc">
              <a:avLst>
                <a:gd name="adj1" fmla="val 10967561"/>
                <a:gd name="adj2" fmla="val 0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AU" sz="1350"/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0EE21B9B-FA6D-478E-851C-7008CF038832}"/>
                </a:ext>
              </a:extLst>
            </p:cNvPr>
            <p:cNvGrpSpPr/>
            <p:nvPr/>
          </p:nvGrpSpPr>
          <p:grpSpPr>
            <a:xfrm>
              <a:off x="3131840" y="1462482"/>
              <a:ext cx="5544616" cy="792088"/>
              <a:chOff x="3131840" y="2852936"/>
              <a:chExt cx="4744144" cy="792088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09ABC891-30B6-44D5-868A-266F8E414D68}"/>
                  </a:ext>
                </a:extLst>
              </p:cNvPr>
              <p:cNvCxnSpPr/>
              <p:nvPr/>
            </p:nvCxnSpPr>
            <p:spPr>
              <a:xfrm>
                <a:off x="3131840" y="2852936"/>
                <a:ext cx="0" cy="792088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B53D26D9-E281-44CF-BF4C-B365D88B8A5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31840" y="3645024"/>
                <a:ext cx="4744144" cy="0"/>
              </a:xfrm>
              <a:prstGeom prst="line">
                <a:avLst/>
              </a:prstGeom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063890F7-DF14-4E6D-AD88-E052308B11F5}"/>
              </a:ext>
            </a:extLst>
          </p:cNvPr>
          <p:cNvSpPr txBox="1"/>
          <p:nvPr/>
        </p:nvSpPr>
        <p:spPr>
          <a:xfrm>
            <a:off x="3183929" y="2247200"/>
            <a:ext cx="13396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FSJ spanning BSJ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A31DF6C-ED2A-4960-A3B4-152236C39D8D}"/>
              </a:ext>
            </a:extLst>
          </p:cNvPr>
          <p:cNvSpPr txBox="1"/>
          <p:nvPr/>
        </p:nvSpPr>
        <p:spPr>
          <a:xfrm>
            <a:off x="2510898" y="2051720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FSJ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FB28D25-A0DA-4EFD-8967-853C006C885F}"/>
              </a:ext>
            </a:extLst>
          </p:cNvPr>
          <p:cNvSpPr txBox="1"/>
          <p:nvPr/>
        </p:nvSpPr>
        <p:spPr>
          <a:xfrm>
            <a:off x="2510898" y="3876346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FSJ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159B4DD-164E-4436-9B38-91CDB89E9897}"/>
              </a:ext>
            </a:extLst>
          </p:cNvPr>
          <p:cNvSpPr txBox="1"/>
          <p:nvPr/>
        </p:nvSpPr>
        <p:spPr>
          <a:xfrm>
            <a:off x="2510898" y="3397261"/>
            <a:ext cx="41312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BSJ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9343EE9-62A2-4EAE-8266-3160326A4048}"/>
              </a:ext>
            </a:extLst>
          </p:cNvPr>
          <p:cNvSpPr txBox="1"/>
          <p:nvPr/>
        </p:nvSpPr>
        <p:spPr>
          <a:xfrm>
            <a:off x="2510898" y="1187624"/>
            <a:ext cx="41312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BSJ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C4F85B1-63E5-4E1A-B3FC-7B64DFE724CC}"/>
              </a:ext>
            </a:extLst>
          </p:cNvPr>
          <p:cNvSpPr txBox="1"/>
          <p:nvPr/>
        </p:nvSpPr>
        <p:spPr>
          <a:xfrm rot="16200000">
            <a:off x="1693013" y="1628899"/>
            <a:ext cx="6751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Count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F67A674-CC12-48CF-AB39-827394AADF4E}"/>
              </a:ext>
            </a:extLst>
          </p:cNvPr>
          <p:cNvSpPr txBox="1"/>
          <p:nvPr/>
        </p:nvSpPr>
        <p:spPr>
          <a:xfrm rot="16200000">
            <a:off x="1658512" y="3726305"/>
            <a:ext cx="6751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Counts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398497EE-CB97-4985-8738-6118EE350A09}"/>
              </a:ext>
            </a:extLst>
          </p:cNvPr>
          <p:cNvSpPr/>
          <p:nvPr/>
        </p:nvSpPr>
        <p:spPr>
          <a:xfrm>
            <a:off x="103405" y="6444208"/>
            <a:ext cx="6606733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6</a:t>
            </a:r>
          </a:p>
          <a:p>
            <a:r>
              <a:rPr lang="en-AU" dirty="0" err="1"/>
              <a:t>Jeck</a:t>
            </a:r>
            <a:r>
              <a:rPr lang="en-AU" dirty="0"/>
              <a:t> et al proposed two models of </a:t>
            </a:r>
            <a:r>
              <a:rPr lang="en-AU" dirty="0" err="1"/>
              <a:t>circRNA</a:t>
            </a:r>
            <a:r>
              <a:rPr lang="en-AU" dirty="0"/>
              <a:t> biogenesis. These models would have produce specific splice junctions. A) Model 1 proposes that a BSJ is derived from an alternative splicing event, therefore would predict a FSJ that spans an existing BSJ. B) Model 2 proposed that </a:t>
            </a:r>
            <a:r>
              <a:rPr lang="en-AU" dirty="0" err="1"/>
              <a:t>circRNAs</a:t>
            </a:r>
            <a:r>
              <a:rPr lang="en-AU" dirty="0"/>
              <a:t> are made independent of parental transcripts therefore would predicts that no FSJ would span an existing BSJ.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C1B79D-DF23-401E-BF19-B0EBD2777C7D}"/>
              </a:ext>
            </a:extLst>
          </p:cNvPr>
          <p:cNvSpPr txBox="1"/>
          <p:nvPr/>
        </p:nvSpPr>
        <p:spPr>
          <a:xfrm>
            <a:off x="116632" y="89959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9F08C95-D915-4B5E-BE37-38A960F1379B}"/>
              </a:ext>
            </a:extLst>
          </p:cNvPr>
          <p:cNvSpPr txBox="1"/>
          <p:nvPr/>
        </p:nvSpPr>
        <p:spPr>
          <a:xfrm>
            <a:off x="116632" y="298782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11742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7324AC4B-B1AB-4CFE-A9D0-F4E5ECB464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69" b="14759"/>
          <a:stretch/>
        </p:blipFill>
        <p:spPr>
          <a:xfrm>
            <a:off x="1269550" y="2051720"/>
            <a:ext cx="2260916" cy="171065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9E751F3-EBE6-4177-AF98-BD4EC8EE49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47" b="8431"/>
          <a:stretch/>
        </p:blipFill>
        <p:spPr>
          <a:xfrm>
            <a:off x="1270485" y="4074438"/>
            <a:ext cx="2266526" cy="181339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AB206B6-690F-423D-8793-2BF7B3117E8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704" b="9160"/>
          <a:stretch/>
        </p:blipFill>
        <p:spPr>
          <a:xfrm>
            <a:off x="4030401" y="4058553"/>
            <a:ext cx="2260916" cy="181339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4FF26B8-D363-4091-B317-C2D2960393A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878" b="10816"/>
          <a:stretch/>
        </p:blipFill>
        <p:spPr>
          <a:xfrm>
            <a:off x="4030401" y="2061225"/>
            <a:ext cx="2260916" cy="181339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A929EDC-166D-42FE-85EA-5853EA10B5A2}"/>
              </a:ext>
            </a:extLst>
          </p:cNvPr>
          <p:cNvSpPr txBox="1"/>
          <p:nvPr/>
        </p:nvSpPr>
        <p:spPr>
          <a:xfrm>
            <a:off x="2358043" y="6065387"/>
            <a:ext cx="3439531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50" dirty="0"/>
              <a:t>BSJ abundance relative to parental transcript</a:t>
            </a:r>
          </a:p>
          <a:p>
            <a:pPr algn="ctr"/>
            <a:r>
              <a:rPr lang="en-AU" sz="1200" dirty="0"/>
              <a:t>(BSJ counts / (FSJ counts external to </a:t>
            </a:r>
            <a:r>
              <a:rPr lang="en-AU" sz="1200" dirty="0" err="1"/>
              <a:t>circRNA</a:t>
            </a:r>
            <a:r>
              <a:rPr lang="en-AU" sz="1200" dirty="0"/>
              <a:t>)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8F1064B-304C-44B6-95B4-5C47BD015C03}"/>
              </a:ext>
            </a:extLst>
          </p:cNvPr>
          <p:cNvSpPr txBox="1"/>
          <p:nvPr/>
        </p:nvSpPr>
        <p:spPr>
          <a:xfrm rot="16200000">
            <a:off x="-227075" y="3520002"/>
            <a:ext cx="2324291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350" dirty="0"/>
              <a:t>Proportion of FSJ spanning BSJ</a:t>
            </a:r>
          </a:p>
          <a:p>
            <a:pPr algn="ctr"/>
            <a:r>
              <a:rPr lang="en-AU" sz="1200" dirty="0"/>
              <a:t>(spanning FSJ counts / BSJ counts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07837BB-0E68-4650-9EC9-14731866DBA7}"/>
              </a:ext>
            </a:extLst>
          </p:cNvPr>
          <p:cNvSpPr/>
          <p:nvPr/>
        </p:nvSpPr>
        <p:spPr>
          <a:xfrm>
            <a:off x="260648" y="6930625"/>
            <a:ext cx="64807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7</a:t>
            </a:r>
          </a:p>
          <a:p>
            <a:r>
              <a:rPr lang="en-AU" dirty="0"/>
              <a:t>The proportion of BSJ relative to FSJ from four different data sets. Every example supports model 2 (see supplementary figure 5). </a:t>
            </a:r>
          </a:p>
        </p:txBody>
      </p:sp>
    </p:spTree>
    <p:extLst>
      <p:ext uri="{BB962C8B-B14F-4D97-AF65-F5344CB8AC3E}">
        <p14:creationId xmlns:p14="http://schemas.microsoft.com/office/powerpoint/2010/main" val="29489061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U:\Work Files\Chris Hayward\circRNA stuff\Slc8a1_iPS_t_course\Slc8a1_iPS_day1_b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429" b="18015"/>
          <a:stretch/>
        </p:blipFill>
        <p:spPr bwMode="auto">
          <a:xfrm>
            <a:off x="338242" y="2154589"/>
            <a:ext cx="4291743" cy="115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U:\Work Files\Chris Hayward\circRNA stuff\Slc8a1_iPS_t_course\Slc8a1_iPS_day0_c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28" b="17203"/>
          <a:stretch/>
        </p:blipFill>
        <p:spPr bwMode="auto">
          <a:xfrm>
            <a:off x="332656" y="957192"/>
            <a:ext cx="4297329" cy="11824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U:\Work Files\Chris Hayward\circRNA stuff\Slc8a1_iPS_t_course\Slc8a1_iPS_day5_a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526" b="16086"/>
          <a:stretch/>
        </p:blipFill>
        <p:spPr bwMode="auto">
          <a:xfrm>
            <a:off x="365829" y="3389012"/>
            <a:ext cx="4235873" cy="1238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U:\Work Files\Chris Hayward\circRNA stuff\Slc8a1_iPS_t_course\Slc8a1_iPS_day7_c.PN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487" b="19497"/>
          <a:stretch/>
        </p:blipFill>
        <p:spPr bwMode="auto">
          <a:xfrm>
            <a:off x="355807" y="4674869"/>
            <a:ext cx="4297329" cy="11936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U:\Work Files\Chris Hayward\circRNA stuff\Slc8a1_iPS_t_course\Slc8a1_iPS_day17_b.PN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93"/>
          <a:stretch/>
        </p:blipFill>
        <p:spPr bwMode="auto">
          <a:xfrm>
            <a:off x="394915" y="5857857"/>
            <a:ext cx="4258221" cy="1778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78924" y="112758"/>
            <a:ext cx="379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LC8A1       </a:t>
            </a:r>
            <a:r>
              <a:rPr lang="en-US" sz="1600" b="1" dirty="0" err="1"/>
              <a:t>iPS</a:t>
            </a:r>
            <a:r>
              <a:rPr lang="en-US" sz="1600" b="1" dirty="0"/>
              <a:t>  CM differentiation t-course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85771" y="2154589"/>
            <a:ext cx="6669360" cy="5554903"/>
            <a:chOff x="120080" y="3016424"/>
            <a:chExt cx="9337104" cy="7776864"/>
          </a:xfrm>
        </p:grpSpPr>
        <p:cxnSp>
          <p:nvCxnSpPr>
            <p:cNvPr id="5" name="Straight Connector 4"/>
            <p:cNvCxnSpPr/>
            <p:nvPr/>
          </p:nvCxnSpPr>
          <p:spPr>
            <a:xfrm flipH="1">
              <a:off x="120080" y="3016424"/>
              <a:ext cx="9337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120080" y="4672608"/>
              <a:ext cx="9337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120080" y="6400800"/>
              <a:ext cx="9337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H="1">
              <a:off x="120080" y="8201000"/>
              <a:ext cx="9337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120080" y="10793288"/>
              <a:ext cx="9337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Rectangle 5"/>
          <p:cNvSpPr/>
          <p:nvPr/>
        </p:nvSpPr>
        <p:spPr>
          <a:xfrm>
            <a:off x="1340768" y="422274"/>
            <a:ext cx="513434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000" dirty="0"/>
              <a:t>Data set </a:t>
            </a:r>
            <a:r>
              <a:rPr lang="fr-FR" sz="1000" dirty="0" err="1"/>
              <a:t>from</a:t>
            </a:r>
            <a:r>
              <a:rPr lang="fr-FR" sz="1000" dirty="0"/>
              <a:t> </a:t>
            </a:r>
            <a:r>
              <a:rPr lang="fr-FR" sz="1000" dirty="0" err="1"/>
              <a:t>Siede</a:t>
            </a:r>
            <a:r>
              <a:rPr lang="fr-FR" sz="1000" dirty="0"/>
              <a:t> et al (2017)  JMCC   Volume 109, Pages 48–56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8009A8-DBA0-4C51-B794-1A5470392569}"/>
              </a:ext>
            </a:extLst>
          </p:cNvPr>
          <p:cNvSpPr txBox="1"/>
          <p:nvPr/>
        </p:nvSpPr>
        <p:spPr>
          <a:xfrm>
            <a:off x="4629986" y="1187624"/>
            <a:ext cx="3191502" cy="594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DAY  0</a:t>
            </a:r>
          </a:p>
          <a:p>
            <a:r>
              <a:rPr lang="en-AU" sz="1400" dirty="0"/>
              <a:t>(HIPSC)</a:t>
            </a:r>
          </a:p>
          <a:p>
            <a:endParaRPr lang="en-AU" dirty="0"/>
          </a:p>
          <a:p>
            <a:endParaRPr lang="en-AU" dirty="0"/>
          </a:p>
          <a:p>
            <a:r>
              <a:rPr lang="en-AU" dirty="0"/>
              <a:t>DAY 1</a:t>
            </a:r>
          </a:p>
          <a:p>
            <a:r>
              <a:rPr lang="en-AU" sz="1400" dirty="0"/>
              <a:t>(Mesoderm Progenitor)</a:t>
            </a:r>
          </a:p>
          <a:p>
            <a:endParaRPr lang="en-AU" dirty="0"/>
          </a:p>
          <a:p>
            <a:endParaRPr lang="en-AU" dirty="0"/>
          </a:p>
          <a:p>
            <a:endParaRPr lang="en-AU" dirty="0"/>
          </a:p>
          <a:p>
            <a:r>
              <a:rPr lang="en-AU" dirty="0"/>
              <a:t>DAY 5</a:t>
            </a:r>
          </a:p>
          <a:p>
            <a:r>
              <a:rPr lang="en-AU" sz="1400" dirty="0"/>
              <a:t>(Cardiac Mesoderm)</a:t>
            </a:r>
          </a:p>
          <a:p>
            <a:endParaRPr lang="en-AU" dirty="0"/>
          </a:p>
          <a:p>
            <a:endParaRPr lang="en-AU" dirty="0"/>
          </a:p>
          <a:p>
            <a:r>
              <a:rPr lang="en-AU" dirty="0"/>
              <a:t>DAY 7</a:t>
            </a:r>
          </a:p>
          <a:p>
            <a:r>
              <a:rPr lang="en-AU" sz="1400" dirty="0"/>
              <a:t>(Cardiac Progenitor)</a:t>
            </a:r>
          </a:p>
          <a:p>
            <a:endParaRPr lang="en-AU" dirty="0"/>
          </a:p>
          <a:p>
            <a:endParaRPr lang="en-AU" dirty="0"/>
          </a:p>
          <a:p>
            <a:endParaRPr lang="en-AU" dirty="0"/>
          </a:p>
          <a:p>
            <a:r>
              <a:rPr lang="en-AU" dirty="0"/>
              <a:t>DAY 17</a:t>
            </a:r>
          </a:p>
          <a:p>
            <a:r>
              <a:rPr lang="en-AU" sz="1400" dirty="0"/>
              <a:t>(Cardiac Myocyte)</a:t>
            </a:r>
          </a:p>
          <a:p>
            <a:endParaRPr lang="en-AU" dirty="0"/>
          </a:p>
          <a:p>
            <a:endParaRPr lang="en-AU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68CD5C7-B3B7-43F2-A431-FF445F61AC8C}"/>
              </a:ext>
            </a:extLst>
          </p:cNvPr>
          <p:cNvSpPr/>
          <p:nvPr/>
        </p:nvSpPr>
        <p:spPr>
          <a:xfrm>
            <a:off x="116632" y="7901969"/>
            <a:ext cx="670217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8</a:t>
            </a:r>
          </a:p>
          <a:p>
            <a:r>
              <a:rPr lang="en-AU" dirty="0" err="1"/>
              <a:t>Ularcric</a:t>
            </a:r>
            <a:r>
              <a:rPr lang="en-AU" dirty="0"/>
              <a:t> screenshots of Slc8a1 across </a:t>
            </a:r>
            <a:r>
              <a:rPr lang="en-AU" dirty="0" err="1"/>
              <a:t>iPS</a:t>
            </a:r>
            <a:r>
              <a:rPr lang="en-AU" dirty="0"/>
              <a:t> differentiation. A </a:t>
            </a:r>
            <a:r>
              <a:rPr lang="en-AU" dirty="0" err="1"/>
              <a:t>circRNA</a:t>
            </a:r>
            <a:r>
              <a:rPr lang="en-AU" dirty="0"/>
              <a:t> is derived from exon 2 and expression increases throughout differentiation.  </a:t>
            </a:r>
          </a:p>
        </p:txBody>
      </p:sp>
    </p:spTree>
    <p:extLst>
      <p:ext uri="{BB962C8B-B14F-4D97-AF65-F5344CB8AC3E}">
        <p14:creationId xmlns:p14="http://schemas.microsoft.com/office/powerpoint/2010/main" val="19954661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22D4334-3E2A-43DC-955F-074B192CD6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40" y="611560"/>
            <a:ext cx="4005064" cy="202592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F0D1993-9FC8-41EA-A28D-3459513FC2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8680" y="3275856"/>
            <a:ext cx="2498883" cy="352558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B2633E7-CE6C-4FB0-A56D-F01970BB27C2}"/>
              </a:ext>
            </a:extLst>
          </p:cNvPr>
          <p:cNvSpPr/>
          <p:nvPr/>
        </p:nvSpPr>
        <p:spPr>
          <a:xfrm>
            <a:off x="1725904" y="1087041"/>
            <a:ext cx="178532" cy="1584176"/>
          </a:xfrm>
          <a:prstGeom prst="rect">
            <a:avLst/>
          </a:prstGeom>
          <a:solidFill>
            <a:srgbClr val="FFFF00">
              <a:alpha val="2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347B3B8-9236-494A-B30D-FAD674FC77B2}"/>
              </a:ext>
            </a:extLst>
          </p:cNvPr>
          <p:cNvSpPr/>
          <p:nvPr/>
        </p:nvSpPr>
        <p:spPr>
          <a:xfrm>
            <a:off x="2696220" y="1090216"/>
            <a:ext cx="463067" cy="1584176"/>
          </a:xfrm>
          <a:prstGeom prst="rect">
            <a:avLst/>
          </a:prstGeom>
          <a:solidFill>
            <a:srgbClr val="FFFF00">
              <a:alpha val="2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89543741-A36B-4F47-90E2-ABA268AF4176}"/>
              </a:ext>
            </a:extLst>
          </p:cNvPr>
          <p:cNvGrpSpPr/>
          <p:nvPr/>
        </p:nvGrpSpPr>
        <p:grpSpPr>
          <a:xfrm>
            <a:off x="1167224" y="2411760"/>
            <a:ext cx="1350218" cy="734938"/>
            <a:chOff x="567728" y="3275856"/>
            <a:chExt cx="2629654" cy="1233916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665A523-1603-4D14-A4FA-7F2B20D540E2}"/>
                </a:ext>
              </a:extLst>
            </p:cNvPr>
            <p:cNvCxnSpPr>
              <a:cxnSpLocks/>
            </p:cNvCxnSpPr>
            <p:nvPr/>
          </p:nvCxnSpPr>
          <p:spPr>
            <a:xfrm>
              <a:off x="2026935" y="3285636"/>
              <a:ext cx="1170447" cy="1224136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31C59404-E5D5-4010-A2D2-5E0F8F42FA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7728" y="3275856"/>
              <a:ext cx="1170447" cy="1224136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50F34A8F-275B-45D5-81A5-09E1981E96E3}"/>
              </a:ext>
            </a:extLst>
          </p:cNvPr>
          <p:cNvGrpSpPr/>
          <p:nvPr/>
        </p:nvGrpSpPr>
        <p:grpSpPr>
          <a:xfrm>
            <a:off x="3409157" y="4504939"/>
            <a:ext cx="3146892" cy="2089195"/>
            <a:chOff x="3409157" y="5011798"/>
            <a:chExt cx="3146892" cy="2089195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AB0722D9-5F43-409B-BE29-91645571516A}"/>
                </a:ext>
              </a:extLst>
            </p:cNvPr>
            <p:cNvGrpSpPr/>
            <p:nvPr/>
          </p:nvGrpSpPr>
          <p:grpSpPr>
            <a:xfrm>
              <a:off x="4333380" y="5418243"/>
              <a:ext cx="1687908" cy="1584325"/>
              <a:chOff x="3881438" y="7180263"/>
              <a:chExt cx="3719512" cy="1584325"/>
            </a:xfrm>
          </p:grpSpPr>
          <p:sp>
            <p:nvSpPr>
              <p:cNvPr id="13" name="Line 6">
                <a:extLst>
                  <a:ext uri="{FF2B5EF4-FFF2-40B4-BE49-F238E27FC236}">
                    <a16:creationId xmlns:a16="http://schemas.microsoft.com/office/drawing/2014/main" id="{7A04529D-392D-44B9-BD81-83C8D16C10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8451850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" name="Line 7">
                <a:extLst>
                  <a:ext uri="{FF2B5EF4-FFF2-40B4-BE49-F238E27FC236}">
                    <a16:creationId xmlns:a16="http://schemas.microsoft.com/office/drawing/2014/main" id="{6BC57D85-58D4-4EF2-8AC4-C3E0DA2CEB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8134350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" name="Line 8">
                <a:extLst>
                  <a:ext uri="{FF2B5EF4-FFF2-40B4-BE49-F238E27FC236}">
                    <a16:creationId xmlns:a16="http://schemas.microsoft.com/office/drawing/2014/main" id="{D39C7720-00AB-4641-B242-3EADC5636E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7816850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" name="Line 9">
                <a:extLst>
                  <a:ext uri="{FF2B5EF4-FFF2-40B4-BE49-F238E27FC236}">
                    <a16:creationId xmlns:a16="http://schemas.microsoft.com/office/drawing/2014/main" id="{D32CAE12-06EC-4D79-B4F0-9ECCEDCE40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7497763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" name="Line 10">
                <a:extLst>
                  <a:ext uri="{FF2B5EF4-FFF2-40B4-BE49-F238E27FC236}">
                    <a16:creationId xmlns:a16="http://schemas.microsoft.com/office/drawing/2014/main" id="{301F6F2E-20F7-4FD5-9B52-55CC99E49A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7180263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" name="Line 16">
                <a:extLst>
                  <a:ext uri="{FF2B5EF4-FFF2-40B4-BE49-F238E27FC236}">
                    <a16:creationId xmlns:a16="http://schemas.microsoft.com/office/drawing/2014/main" id="{32F0BE65-ABBC-48EC-B2BB-3822F5BF17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1438" y="8764588"/>
                <a:ext cx="3719512" cy="0"/>
              </a:xfrm>
              <a:prstGeom prst="line">
                <a:avLst/>
              </a:prstGeom>
              <a:noFill/>
              <a:ln w="11113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</p:grpSp>
        <p:sp>
          <p:nvSpPr>
            <p:cNvPr id="35" name="Rectangle 26">
              <a:extLst>
                <a:ext uri="{FF2B5EF4-FFF2-40B4-BE49-F238E27FC236}">
                  <a16:creationId xmlns:a16="http://schemas.microsoft.com/office/drawing/2014/main" id="{4C46C9F7-4238-41B4-9AC6-00584D6F6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0991" y="5011798"/>
              <a:ext cx="1635319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Ptk2 </a:t>
              </a:r>
              <a:r>
                <a:rPr kumimoji="0" lang="en-US" altLang="en-US" sz="1300" b="0" i="0" u="none" strike="noStrike" cap="none" normalizeH="0" baseline="0" dirty="0" err="1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circRNA</a:t>
              </a: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 expression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733B21F-4677-4B11-A9B8-CF471C97D428}"/>
                </a:ext>
              </a:extLst>
            </p:cNvPr>
            <p:cNvSpPr txBox="1"/>
            <p:nvPr/>
          </p:nvSpPr>
          <p:spPr>
            <a:xfrm rot="5400000">
              <a:off x="6054982" y="5951805"/>
              <a:ext cx="694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/>
                <a:t>Counts</a:t>
              </a: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BEFDB99C-2941-466A-976E-E17FCF085AAE}"/>
                </a:ext>
              </a:extLst>
            </p:cNvPr>
            <p:cNvGrpSpPr/>
            <p:nvPr/>
          </p:nvGrpSpPr>
          <p:grpSpPr>
            <a:xfrm>
              <a:off x="4704855" y="5759555"/>
              <a:ext cx="1059656" cy="1243013"/>
              <a:chOff x="4252913" y="7521575"/>
              <a:chExt cx="2976562" cy="1243013"/>
            </a:xfrm>
          </p:grpSpPr>
          <p:sp>
            <p:nvSpPr>
              <p:cNvPr id="18" name="Freeform 11">
                <a:extLst>
                  <a:ext uri="{FF2B5EF4-FFF2-40B4-BE49-F238E27FC236}">
                    <a16:creationId xmlns:a16="http://schemas.microsoft.com/office/drawing/2014/main" id="{773B1A80-00E8-408E-A40D-4CCEB06C366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252913" y="8059738"/>
                <a:ext cx="2976562" cy="704850"/>
              </a:xfrm>
              <a:custGeom>
                <a:avLst/>
                <a:gdLst>
                  <a:gd name="T0" fmla="*/ 0 w 1875"/>
                  <a:gd name="T1" fmla="*/ 418 h 444"/>
                  <a:gd name="T2" fmla="*/ 314 w 1875"/>
                  <a:gd name="T3" fmla="*/ 418 h 444"/>
                  <a:gd name="T4" fmla="*/ 314 w 1875"/>
                  <a:gd name="T5" fmla="*/ 444 h 444"/>
                  <a:gd name="T6" fmla="*/ 0 w 1875"/>
                  <a:gd name="T7" fmla="*/ 444 h 444"/>
                  <a:gd name="T8" fmla="*/ 0 w 1875"/>
                  <a:gd name="T9" fmla="*/ 418 h 444"/>
                  <a:gd name="T10" fmla="*/ 782 w 1875"/>
                  <a:gd name="T11" fmla="*/ 335 h 444"/>
                  <a:gd name="T12" fmla="*/ 1093 w 1875"/>
                  <a:gd name="T13" fmla="*/ 335 h 444"/>
                  <a:gd name="T14" fmla="*/ 1093 w 1875"/>
                  <a:gd name="T15" fmla="*/ 444 h 444"/>
                  <a:gd name="T16" fmla="*/ 782 w 1875"/>
                  <a:gd name="T17" fmla="*/ 444 h 444"/>
                  <a:gd name="T18" fmla="*/ 782 w 1875"/>
                  <a:gd name="T19" fmla="*/ 335 h 444"/>
                  <a:gd name="T20" fmla="*/ 1560 w 1875"/>
                  <a:gd name="T21" fmla="*/ 0 h 444"/>
                  <a:gd name="T22" fmla="*/ 1875 w 1875"/>
                  <a:gd name="T23" fmla="*/ 0 h 444"/>
                  <a:gd name="T24" fmla="*/ 1875 w 1875"/>
                  <a:gd name="T25" fmla="*/ 444 h 444"/>
                  <a:gd name="T26" fmla="*/ 1560 w 1875"/>
                  <a:gd name="T27" fmla="*/ 444 h 444"/>
                  <a:gd name="T28" fmla="*/ 1560 w 1875"/>
                  <a:gd name="T29" fmla="*/ 0 h 4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875" h="444">
                    <a:moveTo>
                      <a:pt x="0" y="418"/>
                    </a:moveTo>
                    <a:lnTo>
                      <a:pt x="314" y="418"/>
                    </a:lnTo>
                    <a:lnTo>
                      <a:pt x="314" y="444"/>
                    </a:lnTo>
                    <a:lnTo>
                      <a:pt x="0" y="444"/>
                    </a:lnTo>
                    <a:lnTo>
                      <a:pt x="0" y="418"/>
                    </a:lnTo>
                    <a:close/>
                    <a:moveTo>
                      <a:pt x="782" y="335"/>
                    </a:moveTo>
                    <a:lnTo>
                      <a:pt x="1093" y="335"/>
                    </a:lnTo>
                    <a:lnTo>
                      <a:pt x="1093" y="444"/>
                    </a:lnTo>
                    <a:lnTo>
                      <a:pt x="782" y="444"/>
                    </a:lnTo>
                    <a:lnTo>
                      <a:pt x="782" y="335"/>
                    </a:lnTo>
                    <a:close/>
                    <a:moveTo>
                      <a:pt x="1560" y="0"/>
                    </a:moveTo>
                    <a:lnTo>
                      <a:pt x="1875" y="0"/>
                    </a:lnTo>
                    <a:lnTo>
                      <a:pt x="1875" y="444"/>
                    </a:lnTo>
                    <a:lnTo>
                      <a:pt x="1560" y="444"/>
                    </a:lnTo>
                    <a:lnTo>
                      <a:pt x="1560" y="0"/>
                    </a:lnTo>
                    <a:close/>
                  </a:path>
                </a:pathLst>
              </a:custGeom>
              <a:solidFill>
                <a:srgbClr val="7F7F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" name="Freeform 12">
                <a:extLst>
                  <a:ext uri="{FF2B5EF4-FFF2-40B4-BE49-F238E27FC236}">
                    <a16:creationId xmlns:a16="http://schemas.microsoft.com/office/drawing/2014/main" id="{62AA36BA-F10E-46A3-AC17-7775E43BDB8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252913" y="7885113"/>
                <a:ext cx="2976562" cy="838200"/>
              </a:xfrm>
              <a:custGeom>
                <a:avLst/>
                <a:gdLst>
                  <a:gd name="T0" fmla="*/ 0 w 1875"/>
                  <a:gd name="T1" fmla="*/ 525 h 528"/>
                  <a:gd name="T2" fmla="*/ 314 w 1875"/>
                  <a:gd name="T3" fmla="*/ 525 h 528"/>
                  <a:gd name="T4" fmla="*/ 314 w 1875"/>
                  <a:gd name="T5" fmla="*/ 528 h 528"/>
                  <a:gd name="T6" fmla="*/ 0 w 1875"/>
                  <a:gd name="T7" fmla="*/ 528 h 528"/>
                  <a:gd name="T8" fmla="*/ 0 w 1875"/>
                  <a:gd name="T9" fmla="*/ 525 h 528"/>
                  <a:gd name="T10" fmla="*/ 782 w 1875"/>
                  <a:gd name="T11" fmla="*/ 412 h 528"/>
                  <a:gd name="T12" fmla="*/ 1093 w 1875"/>
                  <a:gd name="T13" fmla="*/ 412 h 528"/>
                  <a:gd name="T14" fmla="*/ 1093 w 1875"/>
                  <a:gd name="T15" fmla="*/ 445 h 528"/>
                  <a:gd name="T16" fmla="*/ 782 w 1875"/>
                  <a:gd name="T17" fmla="*/ 445 h 528"/>
                  <a:gd name="T18" fmla="*/ 782 w 1875"/>
                  <a:gd name="T19" fmla="*/ 412 h 528"/>
                  <a:gd name="T20" fmla="*/ 1560 w 1875"/>
                  <a:gd name="T21" fmla="*/ 0 h 528"/>
                  <a:gd name="T22" fmla="*/ 1875 w 1875"/>
                  <a:gd name="T23" fmla="*/ 0 h 528"/>
                  <a:gd name="T24" fmla="*/ 1875 w 1875"/>
                  <a:gd name="T25" fmla="*/ 110 h 528"/>
                  <a:gd name="T26" fmla="*/ 1560 w 1875"/>
                  <a:gd name="T27" fmla="*/ 110 h 528"/>
                  <a:gd name="T28" fmla="*/ 1560 w 1875"/>
                  <a:gd name="T29" fmla="*/ 0 h 5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875" h="528">
                    <a:moveTo>
                      <a:pt x="0" y="525"/>
                    </a:moveTo>
                    <a:lnTo>
                      <a:pt x="314" y="525"/>
                    </a:lnTo>
                    <a:lnTo>
                      <a:pt x="314" y="528"/>
                    </a:lnTo>
                    <a:lnTo>
                      <a:pt x="0" y="528"/>
                    </a:lnTo>
                    <a:lnTo>
                      <a:pt x="0" y="525"/>
                    </a:lnTo>
                    <a:close/>
                    <a:moveTo>
                      <a:pt x="782" y="412"/>
                    </a:moveTo>
                    <a:lnTo>
                      <a:pt x="1093" y="412"/>
                    </a:lnTo>
                    <a:lnTo>
                      <a:pt x="1093" y="445"/>
                    </a:lnTo>
                    <a:lnTo>
                      <a:pt x="782" y="445"/>
                    </a:lnTo>
                    <a:lnTo>
                      <a:pt x="782" y="412"/>
                    </a:lnTo>
                    <a:close/>
                    <a:moveTo>
                      <a:pt x="1560" y="0"/>
                    </a:moveTo>
                    <a:lnTo>
                      <a:pt x="1875" y="0"/>
                    </a:lnTo>
                    <a:lnTo>
                      <a:pt x="1875" y="110"/>
                    </a:lnTo>
                    <a:lnTo>
                      <a:pt x="1560" y="110"/>
                    </a:lnTo>
                    <a:lnTo>
                      <a:pt x="1560" y="0"/>
                    </a:lnTo>
                    <a:close/>
                  </a:path>
                </a:pathLst>
              </a:custGeom>
              <a:solidFill>
                <a:srgbClr val="FFC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0" name="Freeform 13">
                <a:extLst>
                  <a:ext uri="{FF2B5EF4-FFF2-40B4-BE49-F238E27FC236}">
                    <a16:creationId xmlns:a16="http://schemas.microsoft.com/office/drawing/2014/main" id="{1215624A-697A-48E8-BA13-E4A3AFA9E12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494338" y="7862888"/>
                <a:ext cx="1735137" cy="676275"/>
              </a:xfrm>
              <a:custGeom>
                <a:avLst/>
                <a:gdLst>
                  <a:gd name="T0" fmla="*/ 0 w 1093"/>
                  <a:gd name="T1" fmla="*/ 408 h 426"/>
                  <a:gd name="T2" fmla="*/ 311 w 1093"/>
                  <a:gd name="T3" fmla="*/ 408 h 426"/>
                  <a:gd name="T4" fmla="*/ 311 w 1093"/>
                  <a:gd name="T5" fmla="*/ 426 h 426"/>
                  <a:gd name="T6" fmla="*/ 0 w 1093"/>
                  <a:gd name="T7" fmla="*/ 426 h 426"/>
                  <a:gd name="T8" fmla="*/ 0 w 1093"/>
                  <a:gd name="T9" fmla="*/ 408 h 426"/>
                  <a:gd name="T10" fmla="*/ 778 w 1093"/>
                  <a:gd name="T11" fmla="*/ 0 h 426"/>
                  <a:gd name="T12" fmla="*/ 1093 w 1093"/>
                  <a:gd name="T13" fmla="*/ 0 h 426"/>
                  <a:gd name="T14" fmla="*/ 1093 w 1093"/>
                  <a:gd name="T15" fmla="*/ 14 h 426"/>
                  <a:gd name="T16" fmla="*/ 778 w 1093"/>
                  <a:gd name="T17" fmla="*/ 14 h 426"/>
                  <a:gd name="T18" fmla="*/ 778 w 1093"/>
                  <a:gd name="T19" fmla="*/ 0 h 4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093" h="426">
                    <a:moveTo>
                      <a:pt x="0" y="408"/>
                    </a:moveTo>
                    <a:lnTo>
                      <a:pt x="311" y="408"/>
                    </a:lnTo>
                    <a:lnTo>
                      <a:pt x="311" y="426"/>
                    </a:lnTo>
                    <a:lnTo>
                      <a:pt x="0" y="426"/>
                    </a:lnTo>
                    <a:lnTo>
                      <a:pt x="0" y="408"/>
                    </a:lnTo>
                    <a:close/>
                    <a:moveTo>
                      <a:pt x="778" y="0"/>
                    </a:moveTo>
                    <a:lnTo>
                      <a:pt x="1093" y="0"/>
                    </a:lnTo>
                    <a:lnTo>
                      <a:pt x="1093" y="14"/>
                    </a:lnTo>
                    <a:lnTo>
                      <a:pt x="778" y="14"/>
                    </a:lnTo>
                    <a:lnTo>
                      <a:pt x="778" y="0"/>
                    </a:lnTo>
                    <a:close/>
                  </a:path>
                </a:pathLst>
              </a:custGeom>
              <a:solidFill>
                <a:srgbClr val="FF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" name="Freeform 14">
                <a:extLst>
                  <a:ext uri="{FF2B5EF4-FFF2-40B4-BE49-F238E27FC236}">
                    <a16:creationId xmlns:a16="http://schemas.microsoft.com/office/drawing/2014/main" id="{786E83D1-FD50-4702-B17F-C09752EA347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252913" y="7816850"/>
                <a:ext cx="2976562" cy="901700"/>
              </a:xfrm>
              <a:custGeom>
                <a:avLst/>
                <a:gdLst>
                  <a:gd name="T0" fmla="*/ 0 w 1875"/>
                  <a:gd name="T1" fmla="*/ 561 h 568"/>
                  <a:gd name="T2" fmla="*/ 314 w 1875"/>
                  <a:gd name="T3" fmla="*/ 561 h 568"/>
                  <a:gd name="T4" fmla="*/ 314 w 1875"/>
                  <a:gd name="T5" fmla="*/ 568 h 568"/>
                  <a:gd name="T6" fmla="*/ 0 w 1875"/>
                  <a:gd name="T7" fmla="*/ 568 h 568"/>
                  <a:gd name="T8" fmla="*/ 0 w 1875"/>
                  <a:gd name="T9" fmla="*/ 561 h 568"/>
                  <a:gd name="T10" fmla="*/ 782 w 1875"/>
                  <a:gd name="T11" fmla="*/ 433 h 568"/>
                  <a:gd name="T12" fmla="*/ 1093 w 1875"/>
                  <a:gd name="T13" fmla="*/ 433 h 568"/>
                  <a:gd name="T14" fmla="*/ 1093 w 1875"/>
                  <a:gd name="T15" fmla="*/ 437 h 568"/>
                  <a:gd name="T16" fmla="*/ 782 w 1875"/>
                  <a:gd name="T17" fmla="*/ 437 h 568"/>
                  <a:gd name="T18" fmla="*/ 782 w 1875"/>
                  <a:gd name="T19" fmla="*/ 433 h 568"/>
                  <a:gd name="T20" fmla="*/ 1560 w 1875"/>
                  <a:gd name="T21" fmla="*/ 0 h 568"/>
                  <a:gd name="T22" fmla="*/ 1875 w 1875"/>
                  <a:gd name="T23" fmla="*/ 0 h 568"/>
                  <a:gd name="T24" fmla="*/ 1875 w 1875"/>
                  <a:gd name="T25" fmla="*/ 29 h 568"/>
                  <a:gd name="T26" fmla="*/ 1560 w 1875"/>
                  <a:gd name="T27" fmla="*/ 29 h 568"/>
                  <a:gd name="T28" fmla="*/ 1560 w 1875"/>
                  <a:gd name="T29" fmla="*/ 0 h 5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875" h="568">
                    <a:moveTo>
                      <a:pt x="0" y="561"/>
                    </a:moveTo>
                    <a:lnTo>
                      <a:pt x="314" y="561"/>
                    </a:lnTo>
                    <a:lnTo>
                      <a:pt x="314" y="568"/>
                    </a:lnTo>
                    <a:lnTo>
                      <a:pt x="0" y="568"/>
                    </a:lnTo>
                    <a:lnTo>
                      <a:pt x="0" y="561"/>
                    </a:lnTo>
                    <a:close/>
                    <a:moveTo>
                      <a:pt x="782" y="433"/>
                    </a:moveTo>
                    <a:lnTo>
                      <a:pt x="1093" y="433"/>
                    </a:lnTo>
                    <a:lnTo>
                      <a:pt x="1093" y="437"/>
                    </a:lnTo>
                    <a:lnTo>
                      <a:pt x="782" y="437"/>
                    </a:lnTo>
                    <a:lnTo>
                      <a:pt x="782" y="433"/>
                    </a:lnTo>
                    <a:close/>
                    <a:moveTo>
                      <a:pt x="1560" y="0"/>
                    </a:moveTo>
                    <a:lnTo>
                      <a:pt x="1875" y="0"/>
                    </a:lnTo>
                    <a:lnTo>
                      <a:pt x="1875" y="29"/>
                    </a:lnTo>
                    <a:lnTo>
                      <a:pt x="1560" y="29"/>
                    </a:lnTo>
                    <a:lnTo>
                      <a:pt x="1560" y="0"/>
                    </a:lnTo>
                    <a:close/>
                  </a:path>
                </a:pathLst>
              </a:custGeom>
              <a:solidFill>
                <a:srgbClr val="ED7D3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" name="Freeform 15">
                <a:extLst>
                  <a:ext uri="{FF2B5EF4-FFF2-40B4-BE49-F238E27FC236}">
                    <a16:creationId xmlns:a16="http://schemas.microsoft.com/office/drawing/2014/main" id="{2BCF214D-B974-4B5D-9ACE-47AA8CFFB55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494338" y="7521575"/>
                <a:ext cx="1735137" cy="982663"/>
              </a:xfrm>
              <a:custGeom>
                <a:avLst/>
                <a:gdLst>
                  <a:gd name="T0" fmla="*/ 0 w 1093"/>
                  <a:gd name="T1" fmla="*/ 612 h 619"/>
                  <a:gd name="T2" fmla="*/ 311 w 1093"/>
                  <a:gd name="T3" fmla="*/ 612 h 619"/>
                  <a:gd name="T4" fmla="*/ 311 w 1093"/>
                  <a:gd name="T5" fmla="*/ 619 h 619"/>
                  <a:gd name="T6" fmla="*/ 0 w 1093"/>
                  <a:gd name="T7" fmla="*/ 619 h 619"/>
                  <a:gd name="T8" fmla="*/ 0 w 1093"/>
                  <a:gd name="T9" fmla="*/ 612 h 619"/>
                  <a:gd name="T10" fmla="*/ 778 w 1093"/>
                  <a:gd name="T11" fmla="*/ 0 h 619"/>
                  <a:gd name="T12" fmla="*/ 1093 w 1093"/>
                  <a:gd name="T13" fmla="*/ 0 h 619"/>
                  <a:gd name="T14" fmla="*/ 1093 w 1093"/>
                  <a:gd name="T15" fmla="*/ 186 h 619"/>
                  <a:gd name="T16" fmla="*/ 778 w 1093"/>
                  <a:gd name="T17" fmla="*/ 186 h 619"/>
                  <a:gd name="T18" fmla="*/ 778 w 1093"/>
                  <a:gd name="T19" fmla="*/ 0 h 6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093" h="619">
                    <a:moveTo>
                      <a:pt x="0" y="612"/>
                    </a:moveTo>
                    <a:lnTo>
                      <a:pt x="311" y="612"/>
                    </a:lnTo>
                    <a:lnTo>
                      <a:pt x="311" y="619"/>
                    </a:lnTo>
                    <a:lnTo>
                      <a:pt x="0" y="619"/>
                    </a:lnTo>
                    <a:lnTo>
                      <a:pt x="0" y="612"/>
                    </a:lnTo>
                    <a:close/>
                    <a:moveTo>
                      <a:pt x="778" y="0"/>
                    </a:moveTo>
                    <a:lnTo>
                      <a:pt x="1093" y="0"/>
                    </a:lnTo>
                    <a:lnTo>
                      <a:pt x="1093" y="186"/>
                    </a:lnTo>
                    <a:lnTo>
                      <a:pt x="778" y="186"/>
                    </a:lnTo>
                    <a:lnTo>
                      <a:pt x="778" y="0"/>
                    </a:lnTo>
                    <a:close/>
                  </a:path>
                </a:pathLst>
              </a:custGeom>
              <a:solidFill>
                <a:srgbClr val="4472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</p:grpSp>
        <p:sp>
          <p:nvSpPr>
            <p:cNvPr id="24" name="Rectangle 17">
              <a:extLst>
                <a:ext uri="{FF2B5EF4-FFF2-40B4-BE49-F238E27FC236}">
                  <a16:creationId xmlns:a16="http://schemas.microsoft.com/office/drawing/2014/main" id="{14BF7E29-FD63-456A-87DD-601053A0F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6932718"/>
              <a:ext cx="1158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18">
              <a:extLst>
                <a:ext uri="{FF2B5EF4-FFF2-40B4-BE49-F238E27FC236}">
                  <a16:creationId xmlns:a16="http://schemas.microsoft.com/office/drawing/2014/main" id="{723AEC1E-3B5B-4BB0-9A61-C296EDD072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6621568"/>
              <a:ext cx="17462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19">
              <a:extLst>
                <a:ext uri="{FF2B5EF4-FFF2-40B4-BE49-F238E27FC236}">
                  <a16:creationId xmlns:a16="http://schemas.microsoft.com/office/drawing/2014/main" id="{313EE2DD-333D-4616-844C-045DC134B0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6302480"/>
              <a:ext cx="2317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0">
              <a:extLst>
                <a:ext uri="{FF2B5EF4-FFF2-40B4-BE49-F238E27FC236}">
                  <a16:creationId xmlns:a16="http://schemas.microsoft.com/office/drawing/2014/main" id="{6A1480E9-4D5A-4448-8566-DF65816AA0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5984980"/>
              <a:ext cx="2317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5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1">
              <a:extLst>
                <a:ext uri="{FF2B5EF4-FFF2-40B4-BE49-F238E27FC236}">
                  <a16:creationId xmlns:a16="http://schemas.microsoft.com/office/drawing/2014/main" id="{ECE2B517-6EC1-4326-A6F7-FB9D5B79E4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5667480"/>
              <a:ext cx="2317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">
              <a:extLst>
                <a:ext uri="{FF2B5EF4-FFF2-40B4-BE49-F238E27FC236}">
                  <a16:creationId xmlns:a16="http://schemas.microsoft.com/office/drawing/2014/main" id="{56E4C8CD-A5FA-4FFB-A682-83EB1767F1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5837" y="5348393"/>
              <a:ext cx="231775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7">
              <a:extLst>
                <a:ext uri="{FF2B5EF4-FFF2-40B4-BE49-F238E27FC236}">
                  <a16:creationId xmlns:a16="http://schemas.microsoft.com/office/drawing/2014/main" id="{524B638C-F0D7-4369-A615-C8D41B54B1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157" y="6783725"/>
              <a:ext cx="131662" cy="131660"/>
            </a:xfrm>
            <a:prstGeom prst="rect">
              <a:avLst/>
            </a:prstGeom>
            <a:solidFill>
              <a:srgbClr val="7F7F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46" name="Rectangle 28">
              <a:extLst>
                <a:ext uri="{FF2B5EF4-FFF2-40B4-BE49-F238E27FC236}">
                  <a16:creationId xmlns:a16="http://schemas.microsoft.com/office/drawing/2014/main" id="{19CF6BFA-4B04-4A5C-AA8C-59E195E70C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024" y="6779989"/>
              <a:ext cx="4460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only BSJ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9">
              <a:extLst>
                <a:ext uri="{FF2B5EF4-FFF2-40B4-BE49-F238E27FC236}">
                  <a16:creationId xmlns:a16="http://schemas.microsoft.com/office/drawing/2014/main" id="{F0A63BC9-D357-4C79-A360-1CEFD9E57A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157" y="6321212"/>
              <a:ext cx="135316" cy="13166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50" name="Rectangle 30">
              <a:extLst>
                <a:ext uri="{FF2B5EF4-FFF2-40B4-BE49-F238E27FC236}">
                  <a16:creationId xmlns:a16="http://schemas.microsoft.com/office/drawing/2014/main" id="{260EFA68-5801-4FE1-A182-9D501A5CF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024" y="6347941"/>
              <a:ext cx="2555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FSJ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31">
              <a:extLst>
                <a:ext uri="{FF2B5EF4-FFF2-40B4-BE49-F238E27FC236}">
                  <a16:creationId xmlns:a16="http://schemas.microsoft.com/office/drawing/2014/main" id="{EEC4237B-88A8-4782-8D0C-3B8718D5B4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157" y="6044769"/>
              <a:ext cx="135316" cy="131660"/>
            </a:xfrm>
            <a:prstGeom prst="rect">
              <a:avLst/>
            </a:prstGeom>
            <a:solidFill>
              <a:srgbClr val="FF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52" name="Rectangle 32">
              <a:extLst>
                <a:ext uri="{FF2B5EF4-FFF2-40B4-BE49-F238E27FC236}">
                  <a16:creationId xmlns:a16="http://schemas.microsoft.com/office/drawing/2014/main" id="{D73AD019-3781-4DA2-B181-1B58C9E56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024" y="6071498"/>
              <a:ext cx="2555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FSJ3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33">
              <a:extLst>
                <a:ext uri="{FF2B5EF4-FFF2-40B4-BE49-F238E27FC236}">
                  <a16:creationId xmlns:a16="http://schemas.microsoft.com/office/drawing/2014/main" id="{3A2B5DA1-B9A2-41B3-ABCA-C2A01AEA44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157" y="5852463"/>
              <a:ext cx="135316" cy="131660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54" name="Rectangle 34">
              <a:extLst>
                <a:ext uri="{FF2B5EF4-FFF2-40B4-BE49-F238E27FC236}">
                  <a16:creationId xmlns:a16="http://schemas.microsoft.com/office/drawing/2014/main" id="{987281C1-B525-458A-B58F-AA8BEAA513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024" y="5843885"/>
              <a:ext cx="2555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FSJ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35">
              <a:extLst>
                <a:ext uri="{FF2B5EF4-FFF2-40B4-BE49-F238E27FC236}">
                  <a16:creationId xmlns:a16="http://schemas.microsoft.com/office/drawing/2014/main" id="{A4951BE3-0CA6-4163-B41C-24A6B0E60B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157" y="5587242"/>
              <a:ext cx="135316" cy="131660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AU"/>
            </a:p>
          </p:txBody>
        </p:sp>
        <p:sp>
          <p:nvSpPr>
            <p:cNvPr id="56" name="Rectangle 36">
              <a:extLst>
                <a:ext uri="{FF2B5EF4-FFF2-40B4-BE49-F238E27FC236}">
                  <a16:creationId xmlns:a16="http://schemas.microsoft.com/office/drawing/2014/main" id="{E7A835D9-AE57-4BE0-B5E6-D2A47B44BF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024" y="5578664"/>
              <a:ext cx="255587" cy="1682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FSJ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84" name="TextBox 83">
            <a:extLst>
              <a:ext uri="{FF2B5EF4-FFF2-40B4-BE49-F238E27FC236}">
                <a16:creationId xmlns:a16="http://schemas.microsoft.com/office/drawing/2014/main" id="{3207B7B0-9341-46A3-9C0F-CE0697AB7BD0}"/>
              </a:ext>
            </a:extLst>
          </p:cNvPr>
          <p:cNvSpPr txBox="1"/>
          <p:nvPr/>
        </p:nvSpPr>
        <p:spPr>
          <a:xfrm>
            <a:off x="188640" y="2671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743A814-BF66-4F74-A33D-5119AF01F9AA}"/>
              </a:ext>
            </a:extLst>
          </p:cNvPr>
          <p:cNvSpPr txBox="1"/>
          <p:nvPr/>
        </p:nvSpPr>
        <p:spPr>
          <a:xfrm>
            <a:off x="3380771" y="388047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A3A696E-1777-446B-8C0C-CCE9A51193A6}"/>
              </a:ext>
            </a:extLst>
          </p:cNvPr>
          <p:cNvSpPr txBox="1"/>
          <p:nvPr/>
        </p:nvSpPr>
        <p:spPr>
          <a:xfrm>
            <a:off x="133321" y="385610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78F2CC36-9393-4D7E-A3FB-60B2A514DAB6}"/>
              </a:ext>
            </a:extLst>
          </p:cNvPr>
          <p:cNvSpPr/>
          <p:nvPr/>
        </p:nvSpPr>
        <p:spPr>
          <a:xfrm>
            <a:off x="0" y="6948264"/>
            <a:ext cx="670217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b="1" dirty="0"/>
              <a:t>Supplementary figure 9: </a:t>
            </a:r>
            <a:r>
              <a:rPr lang="en-AU" dirty="0"/>
              <a:t>Increased read overage from exons that make up </a:t>
            </a:r>
            <a:r>
              <a:rPr lang="en-AU" dirty="0" err="1"/>
              <a:t>circRNAs</a:t>
            </a:r>
            <a:r>
              <a:rPr lang="en-AU" dirty="0"/>
              <a:t> in Ptk2.  A) IGV screen shot of Ptk2 read coverage from identical heart data sets displayed in Figure 5A.  B) Screen shot of  CIRI2-FULL output displaying evidence and quantification of internalised splice junctions.  C) Breakdown of sequence reads that describe internal splice junction usage of </a:t>
            </a:r>
            <a:r>
              <a:rPr lang="en-AU" dirty="0" err="1"/>
              <a:t>circRNA</a:t>
            </a:r>
            <a:r>
              <a:rPr lang="en-AU" dirty="0"/>
              <a:t> as identified by CIRI2-FULL.  </a:t>
            </a:r>
          </a:p>
        </p:txBody>
      </p:sp>
    </p:spTree>
    <p:extLst>
      <p:ext uri="{BB962C8B-B14F-4D97-AF65-F5344CB8AC3E}">
        <p14:creationId xmlns:p14="http://schemas.microsoft.com/office/powerpoint/2010/main" val="2105566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64</TotalTime>
  <Words>855</Words>
  <Application>Microsoft Office PowerPoint</Application>
  <PresentationFormat>On-screen Show (4:3)</PresentationFormat>
  <Paragraphs>170</Paragraphs>
  <Slides>10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Humphreys</dc:creator>
  <cp:lastModifiedBy>David Humphreys</cp:lastModifiedBy>
  <cp:revision>96</cp:revision>
  <cp:lastPrinted>2018-05-10T05:09:26Z</cp:lastPrinted>
  <dcterms:created xsi:type="dcterms:W3CDTF">2017-05-29T01:16:17Z</dcterms:created>
  <dcterms:modified xsi:type="dcterms:W3CDTF">2019-06-06T12:07:09Z</dcterms:modified>
</cp:coreProperties>
</file>